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2056"/>
    <p:restoredTop sz="95994"/>
  </p:normalViewPr>
  <p:slideViewPr>
    <p:cSldViewPr snapToGrid="0">
      <p:cViewPr varScale="1">
        <p:scale>
          <a:sx n="94" d="100"/>
          <a:sy n="94" d="100"/>
        </p:scale>
        <p:origin x="232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7DC8B1-B679-0B04-EB3C-2AAB0FFB2E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56787E-8472-04BD-6E44-AB37B73B2A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2C4689-4F44-5AA6-5B00-6BF9FAF6D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2A2823-270B-DC6C-FE14-0A24BD310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1B1C7D-67CE-46B8-4B5A-B01754BE2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762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7DF06C-A4D1-DC9D-41B5-F695D9084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A213DC-05E9-9BF9-55A3-3C4A942B22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E64A60-EB4B-1C81-FECF-62A455A87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B07DD0-76F5-4B48-15B8-73257BA33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EE37A-A330-1C80-793F-1EA960198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25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BC55FD1-29F9-375F-FE73-AE2E86B78B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B842CF-A196-69C3-867C-6A7D97A43E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3E577E-6295-1B31-3FFC-6CD984BC3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550A5C-319F-52DD-FA14-56717A1B0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BC1761-EF10-0150-E7E1-A65274660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425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A106C2-DB00-1ABB-8606-E89127504C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7B8241-DFB9-A372-7ACC-F523E2D08C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43A69B-EB1E-CF14-169F-5C662F6ED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9F9C20-2B71-2615-B74D-66CC349A1E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B52799-9CF7-27FB-DA59-240DBDC30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422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953177-94C8-1DFF-36AB-70716F366A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5DAB63-35FA-2C60-B72A-F2E4EE8B09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7F229F-5F4A-692A-690E-B639462C7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59983E-DD03-E7C0-4B6F-0BB05C753A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E71DD8-8BBE-4FDF-6453-6DFB0C182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083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A0E1D7-125F-4271-C411-CD47E27265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B51679-919D-0D1B-7F1F-21C1B39075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88DDBD-4CF6-10E9-07D7-3885F29B95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D53C96-C70D-59D7-28CF-72C954CF2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2DAB8D-B5D4-1D4C-A9E3-E67EE3EFE4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ABEBB6-5AE2-77B9-DA60-0BDA95CF1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8149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6D6FC-21FA-A271-AAE5-CB20C62472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7B520B-394F-7A7D-E2C5-FBA1DA29B3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1F16D3-E78B-C9E8-6745-EC201CCF4F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BFD144-B32E-14DF-2EF3-844A9D5CD9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0445C6-8D28-A9A8-73B2-39791B2CE2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A12892-77C5-A511-BB97-6AC5A0BE7A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7F82BF-FCE9-68F4-580A-B6EFB49F10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20CFE4-148D-92F5-4980-710AC989E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74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196038-0F77-8645-C140-FD737786BF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849BE22-272B-034C-53E4-C244F2FC80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0FB41FE-136C-3EC7-66F0-38993C7949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1276DC-5098-98B0-0AA1-8AC3CB482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312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8CBF60-3A56-D74C-2D45-77725C6A1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7A1AF9-56DD-8AD4-CF7C-4A3A84C5C0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D7FF63-6A4C-1FA8-72D2-C018F9462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23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33FDBE-B31B-E932-C580-819AAE3DB9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582BB0-33BF-79CE-62CC-1C84732FD7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09DCBC-F834-8AEE-437B-F337B8A23C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BA16A4-6501-195F-E70D-69B825D33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01B9C5-BC14-95A0-EE9E-184D93D49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14EB4-B4B9-2A68-CCD3-CEF1E2C468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2745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10DB3B-133B-ABFF-CAF2-77A8F7C53C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82323F-BBC2-DF7B-B6C3-DC46CDFD16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82F9FF-5224-8406-E63E-69D42CD1B8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0F66E1-0DB6-AE83-F84D-A13C2075F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94EAAC-947E-733D-C270-14242458E9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E840E1-6427-C6EC-D9BB-54C6EF686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56399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324C4F-1323-62BD-9F13-16DB9FC2F1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B4C1E7-598F-0EC6-AD28-C8AC42BED4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187DE5-3829-D937-1DFF-916ADAF9A4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66312-2CF0-8048-9628-715160C56035}" type="datetimeFigureOut">
              <a:rPr lang="en-US" smtClean="0"/>
              <a:t>1/8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06F4A2-BB96-ECCE-89AF-ECBA7D1866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7FFF66-60B6-1811-9D9E-1FF4AE153D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802227-E12E-7441-AE6F-D228F47E58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459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>
            <a:extLst>
              <a:ext uri="{FF2B5EF4-FFF2-40B4-BE49-F238E27FC236}">
                <a16:creationId xmlns:a16="http://schemas.microsoft.com/office/drawing/2014/main" id="{5D651890-D493-E6FB-8DB5-CB0648AA0096}"/>
              </a:ext>
            </a:extLst>
          </p:cNvPr>
          <p:cNvGrpSpPr/>
          <p:nvPr/>
        </p:nvGrpSpPr>
        <p:grpSpPr>
          <a:xfrm>
            <a:off x="129456" y="1975"/>
            <a:ext cx="6863622" cy="6856025"/>
            <a:chOff x="175176" y="291141"/>
            <a:chExt cx="6863622" cy="6856025"/>
          </a:xfrm>
        </p:grpSpPr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6A70E3DC-2880-E42C-E73A-BD193C603873}"/>
                </a:ext>
              </a:extLst>
            </p:cNvPr>
            <p:cNvGrpSpPr/>
            <p:nvPr/>
          </p:nvGrpSpPr>
          <p:grpSpPr>
            <a:xfrm>
              <a:off x="175176" y="291141"/>
              <a:ext cx="6863622" cy="6856025"/>
              <a:chOff x="75060" y="10814"/>
              <a:chExt cx="6863622" cy="6856025"/>
            </a:xfrm>
          </p:grpSpPr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6C77010B-07BC-18CA-31B2-0565ECE3986A}"/>
                  </a:ext>
                </a:extLst>
              </p:cNvPr>
              <p:cNvSpPr txBox="1"/>
              <p:nvPr/>
            </p:nvSpPr>
            <p:spPr>
              <a:xfrm>
                <a:off x="75060" y="5389511"/>
                <a:ext cx="6863622" cy="14773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b="1" dirty="0"/>
                  <a:t>Figure S1</a:t>
                </a:r>
                <a:r>
                  <a:rPr lang="en-US" dirty="0"/>
                  <a:t>: </a:t>
                </a:r>
                <a:r>
                  <a:rPr lang="en-US" dirty="0" err="1"/>
                  <a:t>ER:melanosome</a:t>
                </a:r>
                <a:r>
                  <a:rPr lang="en-US" dirty="0"/>
                  <a:t> MCS in RPE from human and porcine tissue. </a:t>
                </a:r>
                <a:r>
                  <a:rPr lang="en-US" b="1" dirty="0"/>
                  <a:t>A</a:t>
                </a:r>
                <a:r>
                  <a:rPr lang="en-US" dirty="0"/>
                  <a:t>) Ultrathin sections through the retina of human (upper panel) or porcine (lower panel) eyes were imaged by transmission electron microscopy. Scale bar, 250nm. </a:t>
                </a:r>
                <a:r>
                  <a:rPr lang="en-US" b="1" dirty="0"/>
                  <a:t>B</a:t>
                </a:r>
                <a:r>
                  <a:rPr lang="en-US" dirty="0"/>
                  <a:t>) Higher magnification of boxed regions within A, with the ER at MCS false-</a:t>
                </a:r>
                <a:r>
                  <a:rPr lang="en-US" dirty="0" err="1"/>
                  <a:t>coloured</a:t>
                </a:r>
                <a:r>
                  <a:rPr lang="en-US" dirty="0"/>
                  <a:t> lilac. Scale bar, 100nm.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49DE0B22-84E9-46F0-5B32-5A1730230858}"/>
                  </a:ext>
                </a:extLst>
              </p:cNvPr>
              <p:cNvSpPr txBox="1"/>
              <p:nvPr/>
            </p:nvSpPr>
            <p:spPr>
              <a:xfrm>
                <a:off x="366590" y="10814"/>
                <a:ext cx="5878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A.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AC074CA-1E0C-7890-FF1C-D8CF2663D48C}"/>
                  </a:ext>
                </a:extLst>
              </p:cNvPr>
              <p:cNvSpPr txBox="1"/>
              <p:nvPr/>
            </p:nvSpPr>
            <p:spPr>
              <a:xfrm>
                <a:off x="3542757" y="10814"/>
                <a:ext cx="5878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b="1" dirty="0"/>
                  <a:t>B.</a:t>
                </a:r>
              </a:p>
            </p:txBody>
          </p: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565764AD-DA6C-00A7-2C59-29A772C74365}"/>
                  </a:ext>
                </a:extLst>
              </p:cNvPr>
              <p:cNvGrpSpPr/>
              <p:nvPr/>
            </p:nvGrpSpPr>
            <p:grpSpPr>
              <a:xfrm>
                <a:off x="147686" y="361075"/>
                <a:ext cx="6679644" cy="5048770"/>
                <a:chOff x="6612637" y="251187"/>
                <a:chExt cx="6679644" cy="5048770"/>
              </a:xfrm>
            </p:grpSpPr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C767F35D-3E96-572C-366B-1F2653EBBD9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screen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8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6612637" y="251187"/>
                  <a:ext cx="6679644" cy="5048770"/>
                </a:xfrm>
                <a:prstGeom prst="rect">
                  <a:avLst/>
                </a:prstGeom>
              </p:spPr>
            </p:pic>
            <p:sp>
              <p:nvSpPr>
                <p:cNvPr id="6" name="Freeform 5">
                  <a:extLst>
                    <a:ext uri="{FF2B5EF4-FFF2-40B4-BE49-F238E27FC236}">
                      <a16:creationId xmlns:a16="http://schemas.microsoft.com/office/drawing/2014/main" id="{A3E8FC0F-4393-5A43-74FF-5AACDE460369}"/>
                    </a:ext>
                  </a:extLst>
                </p:cNvPr>
                <p:cNvSpPr/>
                <p:nvPr/>
              </p:nvSpPr>
              <p:spPr>
                <a:xfrm>
                  <a:off x="11588603" y="1257389"/>
                  <a:ext cx="241584" cy="354654"/>
                </a:xfrm>
                <a:custGeom>
                  <a:avLst/>
                  <a:gdLst>
                    <a:gd name="connsiteX0" fmla="*/ 64800 w 331200"/>
                    <a:gd name="connsiteY0" fmla="*/ 484534 h 486214"/>
                    <a:gd name="connsiteX1" fmla="*/ 64800 w 331200"/>
                    <a:gd name="connsiteY1" fmla="*/ 484534 h 486214"/>
                    <a:gd name="connsiteX2" fmla="*/ 151200 w 331200"/>
                    <a:gd name="connsiteY2" fmla="*/ 448534 h 486214"/>
                    <a:gd name="connsiteX3" fmla="*/ 201600 w 331200"/>
                    <a:gd name="connsiteY3" fmla="*/ 383734 h 486214"/>
                    <a:gd name="connsiteX4" fmla="*/ 216000 w 331200"/>
                    <a:gd name="connsiteY4" fmla="*/ 362134 h 486214"/>
                    <a:gd name="connsiteX5" fmla="*/ 230400 w 331200"/>
                    <a:gd name="connsiteY5" fmla="*/ 340534 h 486214"/>
                    <a:gd name="connsiteX6" fmla="*/ 237600 w 331200"/>
                    <a:gd name="connsiteY6" fmla="*/ 318934 h 486214"/>
                    <a:gd name="connsiteX7" fmla="*/ 252000 w 331200"/>
                    <a:gd name="connsiteY7" fmla="*/ 297334 h 486214"/>
                    <a:gd name="connsiteX8" fmla="*/ 259200 w 331200"/>
                    <a:gd name="connsiteY8" fmla="*/ 275734 h 486214"/>
                    <a:gd name="connsiteX9" fmla="*/ 273600 w 331200"/>
                    <a:gd name="connsiteY9" fmla="*/ 254134 h 486214"/>
                    <a:gd name="connsiteX10" fmla="*/ 280800 w 331200"/>
                    <a:gd name="connsiteY10" fmla="*/ 232534 h 486214"/>
                    <a:gd name="connsiteX11" fmla="*/ 302400 w 331200"/>
                    <a:gd name="connsiteY11" fmla="*/ 189334 h 486214"/>
                    <a:gd name="connsiteX12" fmla="*/ 309600 w 331200"/>
                    <a:gd name="connsiteY12" fmla="*/ 131734 h 486214"/>
                    <a:gd name="connsiteX13" fmla="*/ 331200 w 331200"/>
                    <a:gd name="connsiteY13" fmla="*/ 52534 h 486214"/>
                    <a:gd name="connsiteX14" fmla="*/ 324000 w 331200"/>
                    <a:gd name="connsiteY14" fmla="*/ 2134 h 486214"/>
                    <a:gd name="connsiteX15" fmla="*/ 302400 w 331200"/>
                    <a:gd name="connsiteY15" fmla="*/ 9334 h 486214"/>
                    <a:gd name="connsiteX16" fmla="*/ 280800 w 331200"/>
                    <a:gd name="connsiteY16" fmla="*/ 30934 h 486214"/>
                    <a:gd name="connsiteX17" fmla="*/ 266400 w 331200"/>
                    <a:gd name="connsiteY17" fmla="*/ 74134 h 486214"/>
                    <a:gd name="connsiteX18" fmla="*/ 259200 w 331200"/>
                    <a:gd name="connsiteY18" fmla="*/ 95734 h 486214"/>
                    <a:gd name="connsiteX19" fmla="*/ 244800 w 331200"/>
                    <a:gd name="connsiteY19" fmla="*/ 153334 h 486214"/>
                    <a:gd name="connsiteX20" fmla="*/ 237600 w 331200"/>
                    <a:gd name="connsiteY20" fmla="*/ 174934 h 486214"/>
                    <a:gd name="connsiteX21" fmla="*/ 194400 w 331200"/>
                    <a:gd name="connsiteY21" fmla="*/ 218134 h 486214"/>
                    <a:gd name="connsiteX22" fmla="*/ 151200 w 331200"/>
                    <a:gd name="connsiteY22" fmla="*/ 254134 h 486214"/>
                    <a:gd name="connsiteX23" fmla="*/ 108000 w 331200"/>
                    <a:gd name="connsiteY23" fmla="*/ 282934 h 486214"/>
                    <a:gd name="connsiteX24" fmla="*/ 57600 w 331200"/>
                    <a:gd name="connsiteY24" fmla="*/ 340534 h 486214"/>
                    <a:gd name="connsiteX25" fmla="*/ 43200 w 331200"/>
                    <a:gd name="connsiteY25" fmla="*/ 362134 h 486214"/>
                    <a:gd name="connsiteX26" fmla="*/ 21600 w 331200"/>
                    <a:gd name="connsiteY26" fmla="*/ 376534 h 486214"/>
                    <a:gd name="connsiteX27" fmla="*/ 14400 w 331200"/>
                    <a:gd name="connsiteY27" fmla="*/ 398134 h 486214"/>
                    <a:gd name="connsiteX28" fmla="*/ 0 w 331200"/>
                    <a:gd name="connsiteY28" fmla="*/ 419734 h 486214"/>
                    <a:gd name="connsiteX29" fmla="*/ 28800 w 331200"/>
                    <a:gd name="connsiteY29" fmla="*/ 484534 h 486214"/>
                    <a:gd name="connsiteX30" fmla="*/ 64800 w 331200"/>
                    <a:gd name="connsiteY30" fmla="*/ 484534 h 48621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</a:cxnLst>
                  <a:rect l="l" t="t" r="r" b="b"/>
                  <a:pathLst>
                    <a:path w="331200" h="486214">
                      <a:moveTo>
                        <a:pt x="64800" y="484534"/>
                      </a:moveTo>
                      <a:lnTo>
                        <a:pt x="64800" y="484534"/>
                      </a:lnTo>
                      <a:cubicBezTo>
                        <a:pt x="102249" y="472051"/>
                        <a:pt x="124170" y="471059"/>
                        <a:pt x="151200" y="448534"/>
                      </a:cubicBezTo>
                      <a:cubicBezTo>
                        <a:pt x="176578" y="427385"/>
                        <a:pt x="181530" y="413839"/>
                        <a:pt x="201600" y="383734"/>
                      </a:cubicBezTo>
                      <a:lnTo>
                        <a:pt x="216000" y="362134"/>
                      </a:lnTo>
                      <a:cubicBezTo>
                        <a:pt x="220800" y="354934"/>
                        <a:pt x="227664" y="348743"/>
                        <a:pt x="230400" y="340534"/>
                      </a:cubicBezTo>
                      <a:cubicBezTo>
                        <a:pt x="232800" y="333334"/>
                        <a:pt x="234206" y="325722"/>
                        <a:pt x="237600" y="318934"/>
                      </a:cubicBezTo>
                      <a:cubicBezTo>
                        <a:pt x="241470" y="311194"/>
                        <a:pt x="248130" y="305074"/>
                        <a:pt x="252000" y="297334"/>
                      </a:cubicBezTo>
                      <a:cubicBezTo>
                        <a:pt x="255394" y="290546"/>
                        <a:pt x="255806" y="282522"/>
                        <a:pt x="259200" y="275734"/>
                      </a:cubicBezTo>
                      <a:cubicBezTo>
                        <a:pt x="263070" y="267994"/>
                        <a:pt x="269730" y="261874"/>
                        <a:pt x="273600" y="254134"/>
                      </a:cubicBezTo>
                      <a:cubicBezTo>
                        <a:pt x="276994" y="247346"/>
                        <a:pt x="277406" y="239322"/>
                        <a:pt x="280800" y="232534"/>
                      </a:cubicBezTo>
                      <a:cubicBezTo>
                        <a:pt x="308715" y="176704"/>
                        <a:pt x="284303" y="243626"/>
                        <a:pt x="302400" y="189334"/>
                      </a:cubicBezTo>
                      <a:cubicBezTo>
                        <a:pt x="304800" y="170134"/>
                        <a:pt x="306034" y="150752"/>
                        <a:pt x="309600" y="131734"/>
                      </a:cubicBezTo>
                      <a:cubicBezTo>
                        <a:pt x="316560" y="94612"/>
                        <a:pt x="321300" y="82233"/>
                        <a:pt x="331200" y="52534"/>
                      </a:cubicBezTo>
                      <a:cubicBezTo>
                        <a:pt x="328800" y="35734"/>
                        <a:pt x="333414" y="16254"/>
                        <a:pt x="324000" y="2134"/>
                      </a:cubicBezTo>
                      <a:cubicBezTo>
                        <a:pt x="319790" y="-4181"/>
                        <a:pt x="308715" y="5124"/>
                        <a:pt x="302400" y="9334"/>
                      </a:cubicBezTo>
                      <a:cubicBezTo>
                        <a:pt x="293928" y="14982"/>
                        <a:pt x="288000" y="23734"/>
                        <a:pt x="280800" y="30934"/>
                      </a:cubicBezTo>
                      <a:lnTo>
                        <a:pt x="266400" y="74134"/>
                      </a:lnTo>
                      <a:cubicBezTo>
                        <a:pt x="264000" y="81334"/>
                        <a:pt x="261041" y="88371"/>
                        <a:pt x="259200" y="95734"/>
                      </a:cubicBezTo>
                      <a:cubicBezTo>
                        <a:pt x="254400" y="114934"/>
                        <a:pt x="251058" y="134559"/>
                        <a:pt x="244800" y="153334"/>
                      </a:cubicBezTo>
                      <a:cubicBezTo>
                        <a:pt x="242400" y="160534"/>
                        <a:pt x="242259" y="168943"/>
                        <a:pt x="237600" y="174934"/>
                      </a:cubicBezTo>
                      <a:cubicBezTo>
                        <a:pt x="225097" y="191009"/>
                        <a:pt x="211344" y="206838"/>
                        <a:pt x="194400" y="218134"/>
                      </a:cubicBezTo>
                      <a:cubicBezTo>
                        <a:pt x="117215" y="269591"/>
                        <a:pt x="234356" y="189457"/>
                        <a:pt x="151200" y="254134"/>
                      </a:cubicBezTo>
                      <a:cubicBezTo>
                        <a:pt x="137539" y="264759"/>
                        <a:pt x="108000" y="282934"/>
                        <a:pt x="108000" y="282934"/>
                      </a:cubicBezTo>
                      <a:cubicBezTo>
                        <a:pt x="74400" y="333334"/>
                        <a:pt x="93600" y="316534"/>
                        <a:pt x="57600" y="340534"/>
                      </a:cubicBezTo>
                      <a:cubicBezTo>
                        <a:pt x="52800" y="347734"/>
                        <a:pt x="49319" y="356015"/>
                        <a:pt x="43200" y="362134"/>
                      </a:cubicBezTo>
                      <a:cubicBezTo>
                        <a:pt x="37081" y="368253"/>
                        <a:pt x="27006" y="369777"/>
                        <a:pt x="21600" y="376534"/>
                      </a:cubicBezTo>
                      <a:cubicBezTo>
                        <a:pt x="16859" y="382460"/>
                        <a:pt x="17794" y="391346"/>
                        <a:pt x="14400" y="398134"/>
                      </a:cubicBezTo>
                      <a:cubicBezTo>
                        <a:pt x="10530" y="405874"/>
                        <a:pt x="4800" y="412534"/>
                        <a:pt x="0" y="419734"/>
                      </a:cubicBezTo>
                      <a:cubicBezTo>
                        <a:pt x="4180" y="444813"/>
                        <a:pt x="151" y="472256"/>
                        <a:pt x="28800" y="484534"/>
                      </a:cubicBezTo>
                      <a:cubicBezTo>
                        <a:pt x="37624" y="488316"/>
                        <a:pt x="58800" y="484534"/>
                        <a:pt x="64800" y="484534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" name="Freeform 6">
                  <a:extLst>
                    <a:ext uri="{FF2B5EF4-FFF2-40B4-BE49-F238E27FC236}">
                      <a16:creationId xmlns:a16="http://schemas.microsoft.com/office/drawing/2014/main" id="{3FCAB87D-827F-9417-8370-E28C57D6DB1A}"/>
                    </a:ext>
                  </a:extLst>
                </p:cNvPr>
                <p:cNvSpPr/>
                <p:nvPr/>
              </p:nvSpPr>
              <p:spPr>
                <a:xfrm>
                  <a:off x="12764048" y="1143405"/>
                  <a:ext cx="405355" cy="241584"/>
                </a:xfrm>
                <a:custGeom>
                  <a:avLst/>
                  <a:gdLst>
                    <a:gd name="connsiteX0" fmla="*/ 8522 w 555722"/>
                    <a:gd name="connsiteY0" fmla="*/ 144000 h 331200"/>
                    <a:gd name="connsiteX1" fmla="*/ 8522 w 555722"/>
                    <a:gd name="connsiteY1" fmla="*/ 144000 h 331200"/>
                    <a:gd name="connsiteX2" fmla="*/ 130922 w 555722"/>
                    <a:gd name="connsiteY2" fmla="*/ 165600 h 331200"/>
                    <a:gd name="connsiteX3" fmla="*/ 174122 w 555722"/>
                    <a:gd name="connsiteY3" fmla="*/ 180000 h 331200"/>
                    <a:gd name="connsiteX4" fmla="*/ 217322 w 555722"/>
                    <a:gd name="connsiteY4" fmla="*/ 208800 h 331200"/>
                    <a:gd name="connsiteX5" fmla="*/ 238922 w 555722"/>
                    <a:gd name="connsiteY5" fmla="*/ 216000 h 331200"/>
                    <a:gd name="connsiteX6" fmla="*/ 260522 w 555722"/>
                    <a:gd name="connsiteY6" fmla="*/ 230400 h 331200"/>
                    <a:gd name="connsiteX7" fmla="*/ 282122 w 555722"/>
                    <a:gd name="connsiteY7" fmla="*/ 237600 h 331200"/>
                    <a:gd name="connsiteX8" fmla="*/ 303722 w 555722"/>
                    <a:gd name="connsiteY8" fmla="*/ 252000 h 331200"/>
                    <a:gd name="connsiteX9" fmla="*/ 325322 w 555722"/>
                    <a:gd name="connsiteY9" fmla="*/ 259200 h 331200"/>
                    <a:gd name="connsiteX10" fmla="*/ 390122 w 555722"/>
                    <a:gd name="connsiteY10" fmla="*/ 302400 h 331200"/>
                    <a:gd name="connsiteX11" fmla="*/ 411722 w 555722"/>
                    <a:gd name="connsiteY11" fmla="*/ 316800 h 331200"/>
                    <a:gd name="connsiteX12" fmla="*/ 454922 w 555722"/>
                    <a:gd name="connsiteY12" fmla="*/ 331200 h 331200"/>
                    <a:gd name="connsiteX13" fmla="*/ 526922 w 555722"/>
                    <a:gd name="connsiteY13" fmla="*/ 324000 h 331200"/>
                    <a:gd name="connsiteX14" fmla="*/ 548522 w 555722"/>
                    <a:gd name="connsiteY14" fmla="*/ 316800 h 331200"/>
                    <a:gd name="connsiteX15" fmla="*/ 555722 w 555722"/>
                    <a:gd name="connsiteY15" fmla="*/ 295200 h 331200"/>
                    <a:gd name="connsiteX16" fmla="*/ 534122 w 555722"/>
                    <a:gd name="connsiteY16" fmla="*/ 208800 h 331200"/>
                    <a:gd name="connsiteX17" fmla="*/ 490922 w 555722"/>
                    <a:gd name="connsiteY17" fmla="*/ 194400 h 331200"/>
                    <a:gd name="connsiteX18" fmla="*/ 426122 w 555722"/>
                    <a:gd name="connsiteY18" fmla="*/ 172800 h 331200"/>
                    <a:gd name="connsiteX19" fmla="*/ 404522 w 555722"/>
                    <a:gd name="connsiteY19" fmla="*/ 165600 h 331200"/>
                    <a:gd name="connsiteX20" fmla="*/ 382922 w 555722"/>
                    <a:gd name="connsiteY20" fmla="*/ 158400 h 331200"/>
                    <a:gd name="connsiteX21" fmla="*/ 318122 w 555722"/>
                    <a:gd name="connsiteY21" fmla="*/ 115200 h 331200"/>
                    <a:gd name="connsiteX22" fmla="*/ 296522 w 555722"/>
                    <a:gd name="connsiteY22" fmla="*/ 100800 h 331200"/>
                    <a:gd name="connsiteX23" fmla="*/ 274922 w 555722"/>
                    <a:gd name="connsiteY23" fmla="*/ 93600 h 331200"/>
                    <a:gd name="connsiteX24" fmla="*/ 231722 w 555722"/>
                    <a:gd name="connsiteY24" fmla="*/ 64800 h 331200"/>
                    <a:gd name="connsiteX25" fmla="*/ 102122 w 555722"/>
                    <a:gd name="connsiteY25" fmla="*/ 21600 h 331200"/>
                    <a:gd name="connsiteX26" fmla="*/ 58922 w 555722"/>
                    <a:gd name="connsiteY26" fmla="*/ 7200 h 331200"/>
                    <a:gd name="connsiteX27" fmla="*/ 37322 w 555722"/>
                    <a:gd name="connsiteY27" fmla="*/ 0 h 331200"/>
                    <a:gd name="connsiteX28" fmla="*/ 8522 w 555722"/>
                    <a:gd name="connsiteY28" fmla="*/ 7200 h 331200"/>
                    <a:gd name="connsiteX29" fmla="*/ 8522 w 555722"/>
                    <a:gd name="connsiteY29" fmla="*/ 100800 h 331200"/>
                    <a:gd name="connsiteX30" fmla="*/ 15722 w 555722"/>
                    <a:gd name="connsiteY30" fmla="*/ 122400 h 331200"/>
                    <a:gd name="connsiteX31" fmla="*/ 8522 w 555722"/>
                    <a:gd name="connsiteY31" fmla="*/ 144000 h 331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</a:cxnLst>
                  <a:rect l="l" t="t" r="r" b="b"/>
                  <a:pathLst>
                    <a:path w="555722" h="331200">
                      <a:moveTo>
                        <a:pt x="8522" y="144000"/>
                      </a:moveTo>
                      <a:lnTo>
                        <a:pt x="8522" y="144000"/>
                      </a:lnTo>
                      <a:cubicBezTo>
                        <a:pt x="60590" y="149785"/>
                        <a:pt x="81744" y="149207"/>
                        <a:pt x="130922" y="165600"/>
                      </a:cubicBezTo>
                      <a:cubicBezTo>
                        <a:pt x="145322" y="170400"/>
                        <a:pt x="161492" y="171580"/>
                        <a:pt x="174122" y="180000"/>
                      </a:cubicBezTo>
                      <a:cubicBezTo>
                        <a:pt x="188522" y="189600"/>
                        <a:pt x="200903" y="203327"/>
                        <a:pt x="217322" y="208800"/>
                      </a:cubicBezTo>
                      <a:cubicBezTo>
                        <a:pt x="224522" y="211200"/>
                        <a:pt x="232134" y="212606"/>
                        <a:pt x="238922" y="216000"/>
                      </a:cubicBezTo>
                      <a:cubicBezTo>
                        <a:pt x="246662" y="219870"/>
                        <a:pt x="252782" y="226530"/>
                        <a:pt x="260522" y="230400"/>
                      </a:cubicBezTo>
                      <a:cubicBezTo>
                        <a:pt x="267310" y="233794"/>
                        <a:pt x="275334" y="234206"/>
                        <a:pt x="282122" y="237600"/>
                      </a:cubicBezTo>
                      <a:cubicBezTo>
                        <a:pt x="289862" y="241470"/>
                        <a:pt x="295982" y="248130"/>
                        <a:pt x="303722" y="252000"/>
                      </a:cubicBezTo>
                      <a:cubicBezTo>
                        <a:pt x="310510" y="255394"/>
                        <a:pt x="318688" y="255514"/>
                        <a:pt x="325322" y="259200"/>
                      </a:cubicBezTo>
                      <a:lnTo>
                        <a:pt x="390122" y="302400"/>
                      </a:lnTo>
                      <a:cubicBezTo>
                        <a:pt x="397322" y="307200"/>
                        <a:pt x="403513" y="314064"/>
                        <a:pt x="411722" y="316800"/>
                      </a:cubicBezTo>
                      <a:lnTo>
                        <a:pt x="454922" y="331200"/>
                      </a:lnTo>
                      <a:cubicBezTo>
                        <a:pt x="478922" y="328800"/>
                        <a:pt x="503083" y="327668"/>
                        <a:pt x="526922" y="324000"/>
                      </a:cubicBezTo>
                      <a:cubicBezTo>
                        <a:pt x="534423" y="322846"/>
                        <a:pt x="543155" y="322167"/>
                        <a:pt x="548522" y="316800"/>
                      </a:cubicBezTo>
                      <a:cubicBezTo>
                        <a:pt x="553889" y="311433"/>
                        <a:pt x="553322" y="302400"/>
                        <a:pt x="555722" y="295200"/>
                      </a:cubicBezTo>
                      <a:cubicBezTo>
                        <a:pt x="554508" y="284276"/>
                        <a:pt x="557813" y="223607"/>
                        <a:pt x="534122" y="208800"/>
                      </a:cubicBezTo>
                      <a:cubicBezTo>
                        <a:pt x="521250" y="200755"/>
                        <a:pt x="505322" y="199200"/>
                        <a:pt x="490922" y="194400"/>
                      </a:cubicBezTo>
                      <a:lnTo>
                        <a:pt x="426122" y="172800"/>
                      </a:lnTo>
                      <a:lnTo>
                        <a:pt x="404522" y="165600"/>
                      </a:lnTo>
                      <a:cubicBezTo>
                        <a:pt x="397322" y="163200"/>
                        <a:pt x="389237" y="162610"/>
                        <a:pt x="382922" y="158400"/>
                      </a:cubicBezTo>
                      <a:lnTo>
                        <a:pt x="318122" y="115200"/>
                      </a:lnTo>
                      <a:cubicBezTo>
                        <a:pt x="310922" y="110400"/>
                        <a:pt x="304731" y="103536"/>
                        <a:pt x="296522" y="100800"/>
                      </a:cubicBezTo>
                      <a:cubicBezTo>
                        <a:pt x="289322" y="98400"/>
                        <a:pt x="281556" y="97286"/>
                        <a:pt x="274922" y="93600"/>
                      </a:cubicBezTo>
                      <a:cubicBezTo>
                        <a:pt x="259793" y="85195"/>
                        <a:pt x="248141" y="70273"/>
                        <a:pt x="231722" y="64800"/>
                      </a:cubicBezTo>
                      <a:lnTo>
                        <a:pt x="102122" y="21600"/>
                      </a:lnTo>
                      <a:lnTo>
                        <a:pt x="58922" y="7200"/>
                      </a:lnTo>
                      <a:lnTo>
                        <a:pt x="37322" y="0"/>
                      </a:lnTo>
                      <a:cubicBezTo>
                        <a:pt x="27722" y="2400"/>
                        <a:pt x="13328" y="-1450"/>
                        <a:pt x="8522" y="7200"/>
                      </a:cubicBezTo>
                      <a:cubicBezTo>
                        <a:pt x="-6518" y="34272"/>
                        <a:pt x="1526" y="72814"/>
                        <a:pt x="8522" y="100800"/>
                      </a:cubicBezTo>
                      <a:cubicBezTo>
                        <a:pt x="10363" y="108163"/>
                        <a:pt x="11817" y="115892"/>
                        <a:pt x="15722" y="122400"/>
                      </a:cubicBezTo>
                      <a:cubicBezTo>
                        <a:pt x="19215" y="128221"/>
                        <a:pt x="9722" y="140400"/>
                        <a:pt x="8522" y="14400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" name="Freeform 7">
                  <a:extLst>
                    <a:ext uri="{FF2B5EF4-FFF2-40B4-BE49-F238E27FC236}">
                      <a16:creationId xmlns:a16="http://schemas.microsoft.com/office/drawing/2014/main" id="{9453F3B5-F152-A3FF-D65E-DC5A3B2B21C6}"/>
                    </a:ext>
                  </a:extLst>
                </p:cNvPr>
                <p:cNvSpPr/>
                <p:nvPr/>
              </p:nvSpPr>
              <p:spPr>
                <a:xfrm>
                  <a:off x="10790326" y="691748"/>
                  <a:ext cx="1234179" cy="693241"/>
                </a:xfrm>
                <a:custGeom>
                  <a:avLst/>
                  <a:gdLst>
                    <a:gd name="connsiteX0" fmla="*/ 1288800 w 1692000"/>
                    <a:gd name="connsiteY0" fmla="*/ 324000 h 950400"/>
                    <a:gd name="connsiteX1" fmla="*/ 1288800 w 1692000"/>
                    <a:gd name="connsiteY1" fmla="*/ 324000 h 950400"/>
                    <a:gd name="connsiteX2" fmla="*/ 1339200 w 1692000"/>
                    <a:gd name="connsiteY2" fmla="*/ 367200 h 950400"/>
                    <a:gd name="connsiteX3" fmla="*/ 1368000 w 1692000"/>
                    <a:gd name="connsiteY3" fmla="*/ 410400 h 950400"/>
                    <a:gd name="connsiteX4" fmla="*/ 1382400 w 1692000"/>
                    <a:gd name="connsiteY4" fmla="*/ 432000 h 950400"/>
                    <a:gd name="connsiteX5" fmla="*/ 1389600 w 1692000"/>
                    <a:gd name="connsiteY5" fmla="*/ 453600 h 950400"/>
                    <a:gd name="connsiteX6" fmla="*/ 1404000 w 1692000"/>
                    <a:gd name="connsiteY6" fmla="*/ 475200 h 950400"/>
                    <a:gd name="connsiteX7" fmla="*/ 1411200 w 1692000"/>
                    <a:gd name="connsiteY7" fmla="*/ 496800 h 950400"/>
                    <a:gd name="connsiteX8" fmla="*/ 1425600 w 1692000"/>
                    <a:gd name="connsiteY8" fmla="*/ 518400 h 950400"/>
                    <a:gd name="connsiteX9" fmla="*/ 1432800 w 1692000"/>
                    <a:gd name="connsiteY9" fmla="*/ 540000 h 950400"/>
                    <a:gd name="connsiteX10" fmla="*/ 1461600 w 1692000"/>
                    <a:gd name="connsiteY10" fmla="*/ 583200 h 950400"/>
                    <a:gd name="connsiteX11" fmla="*/ 1468800 w 1692000"/>
                    <a:gd name="connsiteY11" fmla="*/ 619200 h 950400"/>
                    <a:gd name="connsiteX12" fmla="*/ 1483200 w 1692000"/>
                    <a:gd name="connsiteY12" fmla="*/ 648000 h 950400"/>
                    <a:gd name="connsiteX13" fmla="*/ 1490400 w 1692000"/>
                    <a:gd name="connsiteY13" fmla="*/ 669600 h 950400"/>
                    <a:gd name="connsiteX14" fmla="*/ 1512000 w 1692000"/>
                    <a:gd name="connsiteY14" fmla="*/ 741600 h 950400"/>
                    <a:gd name="connsiteX15" fmla="*/ 1526400 w 1692000"/>
                    <a:gd name="connsiteY15" fmla="*/ 763200 h 950400"/>
                    <a:gd name="connsiteX16" fmla="*/ 1540800 w 1692000"/>
                    <a:gd name="connsiteY16" fmla="*/ 806400 h 950400"/>
                    <a:gd name="connsiteX17" fmla="*/ 1562400 w 1692000"/>
                    <a:gd name="connsiteY17" fmla="*/ 871200 h 950400"/>
                    <a:gd name="connsiteX18" fmla="*/ 1598400 w 1692000"/>
                    <a:gd name="connsiteY18" fmla="*/ 936000 h 950400"/>
                    <a:gd name="connsiteX19" fmla="*/ 1641600 w 1692000"/>
                    <a:gd name="connsiteY19" fmla="*/ 950400 h 950400"/>
                    <a:gd name="connsiteX20" fmla="*/ 1684800 w 1692000"/>
                    <a:gd name="connsiteY20" fmla="*/ 900000 h 950400"/>
                    <a:gd name="connsiteX21" fmla="*/ 1692000 w 1692000"/>
                    <a:gd name="connsiteY21" fmla="*/ 878400 h 950400"/>
                    <a:gd name="connsiteX22" fmla="*/ 1684800 w 1692000"/>
                    <a:gd name="connsiteY22" fmla="*/ 748800 h 950400"/>
                    <a:gd name="connsiteX23" fmla="*/ 1656000 w 1692000"/>
                    <a:gd name="connsiteY23" fmla="*/ 684000 h 950400"/>
                    <a:gd name="connsiteX24" fmla="*/ 1641600 w 1692000"/>
                    <a:gd name="connsiteY24" fmla="*/ 640800 h 950400"/>
                    <a:gd name="connsiteX25" fmla="*/ 1627200 w 1692000"/>
                    <a:gd name="connsiteY25" fmla="*/ 597600 h 950400"/>
                    <a:gd name="connsiteX26" fmla="*/ 1620000 w 1692000"/>
                    <a:gd name="connsiteY26" fmla="*/ 576000 h 950400"/>
                    <a:gd name="connsiteX27" fmla="*/ 1612800 w 1692000"/>
                    <a:gd name="connsiteY27" fmla="*/ 554400 h 950400"/>
                    <a:gd name="connsiteX28" fmla="*/ 1591200 w 1692000"/>
                    <a:gd name="connsiteY28" fmla="*/ 446400 h 950400"/>
                    <a:gd name="connsiteX29" fmla="*/ 1576800 w 1692000"/>
                    <a:gd name="connsiteY29" fmla="*/ 424800 h 950400"/>
                    <a:gd name="connsiteX30" fmla="*/ 1555200 w 1692000"/>
                    <a:gd name="connsiteY30" fmla="*/ 352800 h 950400"/>
                    <a:gd name="connsiteX31" fmla="*/ 1490400 w 1692000"/>
                    <a:gd name="connsiteY31" fmla="*/ 316800 h 950400"/>
                    <a:gd name="connsiteX32" fmla="*/ 1468800 w 1692000"/>
                    <a:gd name="connsiteY32" fmla="*/ 302400 h 950400"/>
                    <a:gd name="connsiteX33" fmla="*/ 1425600 w 1692000"/>
                    <a:gd name="connsiteY33" fmla="*/ 280800 h 950400"/>
                    <a:gd name="connsiteX34" fmla="*/ 1404000 w 1692000"/>
                    <a:gd name="connsiteY34" fmla="*/ 273600 h 950400"/>
                    <a:gd name="connsiteX35" fmla="*/ 1360800 w 1692000"/>
                    <a:gd name="connsiteY35" fmla="*/ 244800 h 950400"/>
                    <a:gd name="connsiteX36" fmla="*/ 1310400 w 1692000"/>
                    <a:gd name="connsiteY36" fmla="*/ 230400 h 950400"/>
                    <a:gd name="connsiteX37" fmla="*/ 1267200 w 1692000"/>
                    <a:gd name="connsiteY37" fmla="*/ 201600 h 950400"/>
                    <a:gd name="connsiteX38" fmla="*/ 1224000 w 1692000"/>
                    <a:gd name="connsiteY38" fmla="*/ 180000 h 950400"/>
                    <a:gd name="connsiteX39" fmla="*/ 1202400 w 1692000"/>
                    <a:gd name="connsiteY39" fmla="*/ 172800 h 950400"/>
                    <a:gd name="connsiteX40" fmla="*/ 1180800 w 1692000"/>
                    <a:gd name="connsiteY40" fmla="*/ 158400 h 950400"/>
                    <a:gd name="connsiteX41" fmla="*/ 1159200 w 1692000"/>
                    <a:gd name="connsiteY41" fmla="*/ 151200 h 950400"/>
                    <a:gd name="connsiteX42" fmla="*/ 1137600 w 1692000"/>
                    <a:gd name="connsiteY42" fmla="*/ 136800 h 950400"/>
                    <a:gd name="connsiteX43" fmla="*/ 1116000 w 1692000"/>
                    <a:gd name="connsiteY43" fmla="*/ 129600 h 950400"/>
                    <a:gd name="connsiteX44" fmla="*/ 1094400 w 1692000"/>
                    <a:gd name="connsiteY44" fmla="*/ 115200 h 950400"/>
                    <a:gd name="connsiteX45" fmla="*/ 1051200 w 1692000"/>
                    <a:gd name="connsiteY45" fmla="*/ 100800 h 950400"/>
                    <a:gd name="connsiteX46" fmla="*/ 1008000 w 1692000"/>
                    <a:gd name="connsiteY46" fmla="*/ 86400 h 950400"/>
                    <a:gd name="connsiteX47" fmla="*/ 986400 w 1692000"/>
                    <a:gd name="connsiteY47" fmla="*/ 79200 h 950400"/>
                    <a:gd name="connsiteX48" fmla="*/ 928800 w 1692000"/>
                    <a:gd name="connsiteY48" fmla="*/ 64800 h 950400"/>
                    <a:gd name="connsiteX49" fmla="*/ 900000 w 1692000"/>
                    <a:gd name="connsiteY49" fmla="*/ 57600 h 950400"/>
                    <a:gd name="connsiteX50" fmla="*/ 856800 w 1692000"/>
                    <a:gd name="connsiteY50" fmla="*/ 43200 h 950400"/>
                    <a:gd name="connsiteX51" fmla="*/ 813600 w 1692000"/>
                    <a:gd name="connsiteY51" fmla="*/ 28800 h 950400"/>
                    <a:gd name="connsiteX52" fmla="*/ 792000 w 1692000"/>
                    <a:gd name="connsiteY52" fmla="*/ 21600 h 950400"/>
                    <a:gd name="connsiteX53" fmla="*/ 741600 w 1692000"/>
                    <a:gd name="connsiteY53" fmla="*/ 0 h 950400"/>
                    <a:gd name="connsiteX54" fmla="*/ 691200 w 1692000"/>
                    <a:gd name="connsiteY54" fmla="*/ 28800 h 950400"/>
                    <a:gd name="connsiteX55" fmla="*/ 727200 w 1692000"/>
                    <a:gd name="connsiteY55" fmla="*/ 57600 h 950400"/>
                    <a:gd name="connsiteX56" fmla="*/ 792000 w 1692000"/>
                    <a:gd name="connsiteY56" fmla="*/ 86400 h 950400"/>
                    <a:gd name="connsiteX57" fmla="*/ 900000 w 1692000"/>
                    <a:gd name="connsiteY57" fmla="*/ 122400 h 950400"/>
                    <a:gd name="connsiteX58" fmla="*/ 921600 w 1692000"/>
                    <a:gd name="connsiteY58" fmla="*/ 129600 h 950400"/>
                    <a:gd name="connsiteX59" fmla="*/ 943200 w 1692000"/>
                    <a:gd name="connsiteY59" fmla="*/ 136800 h 950400"/>
                    <a:gd name="connsiteX60" fmla="*/ 964800 w 1692000"/>
                    <a:gd name="connsiteY60" fmla="*/ 151200 h 950400"/>
                    <a:gd name="connsiteX61" fmla="*/ 986400 w 1692000"/>
                    <a:gd name="connsiteY61" fmla="*/ 158400 h 950400"/>
                    <a:gd name="connsiteX62" fmla="*/ 1051200 w 1692000"/>
                    <a:gd name="connsiteY62" fmla="*/ 201600 h 950400"/>
                    <a:gd name="connsiteX63" fmla="*/ 1072800 w 1692000"/>
                    <a:gd name="connsiteY63" fmla="*/ 216000 h 950400"/>
                    <a:gd name="connsiteX64" fmla="*/ 1094400 w 1692000"/>
                    <a:gd name="connsiteY64" fmla="*/ 223200 h 950400"/>
                    <a:gd name="connsiteX65" fmla="*/ 1116000 w 1692000"/>
                    <a:gd name="connsiteY65" fmla="*/ 244800 h 950400"/>
                    <a:gd name="connsiteX66" fmla="*/ 1094400 w 1692000"/>
                    <a:gd name="connsiteY66" fmla="*/ 252000 h 950400"/>
                    <a:gd name="connsiteX67" fmla="*/ 964800 w 1692000"/>
                    <a:gd name="connsiteY67" fmla="*/ 244800 h 950400"/>
                    <a:gd name="connsiteX68" fmla="*/ 921600 w 1692000"/>
                    <a:gd name="connsiteY68" fmla="*/ 230400 h 950400"/>
                    <a:gd name="connsiteX69" fmla="*/ 900000 w 1692000"/>
                    <a:gd name="connsiteY69" fmla="*/ 223200 h 950400"/>
                    <a:gd name="connsiteX70" fmla="*/ 878400 w 1692000"/>
                    <a:gd name="connsiteY70" fmla="*/ 208800 h 950400"/>
                    <a:gd name="connsiteX71" fmla="*/ 756000 w 1692000"/>
                    <a:gd name="connsiteY71" fmla="*/ 194400 h 950400"/>
                    <a:gd name="connsiteX72" fmla="*/ 684000 w 1692000"/>
                    <a:gd name="connsiteY72" fmla="*/ 172800 h 950400"/>
                    <a:gd name="connsiteX73" fmla="*/ 662400 w 1692000"/>
                    <a:gd name="connsiteY73" fmla="*/ 165600 h 950400"/>
                    <a:gd name="connsiteX74" fmla="*/ 640800 w 1692000"/>
                    <a:gd name="connsiteY74" fmla="*/ 158400 h 950400"/>
                    <a:gd name="connsiteX75" fmla="*/ 583200 w 1692000"/>
                    <a:gd name="connsiteY75" fmla="*/ 136800 h 950400"/>
                    <a:gd name="connsiteX76" fmla="*/ 525600 w 1692000"/>
                    <a:gd name="connsiteY76" fmla="*/ 151200 h 950400"/>
                    <a:gd name="connsiteX77" fmla="*/ 482400 w 1692000"/>
                    <a:gd name="connsiteY77" fmla="*/ 180000 h 950400"/>
                    <a:gd name="connsiteX78" fmla="*/ 460800 w 1692000"/>
                    <a:gd name="connsiteY78" fmla="*/ 194400 h 950400"/>
                    <a:gd name="connsiteX79" fmla="*/ 403200 w 1692000"/>
                    <a:gd name="connsiteY79" fmla="*/ 244800 h 950400"/>
                    <a:gd name="connsiteX80" fmla="*/ 381600 w 1692000"/>
                    <a:gd name="connsiteY80" fmla="*/ 259200 h 950400"/>
                    <a:gd name="connsiteX81" fmla="*/ 360000 w 1692000"/>
                    <a:gd name="connsiteY81" fmla="*/ 273600 h 950400"/>
                    <a:gd name="connsiteX82" fmla="*/ 295200 w 1692000"/>
                    <a:gd name="connsiteY82" fmla="*/ 295200 h 950400"/>
                    <a:gd name="connsiteX83" fmla="*/ 273600 w 1692000"/>
                    <a:gd name="connsiteY83" fmla="*/ 302400 h 950400"/>
                    <a:gd name="connsiteX84" fmla="*/ 216000 w 1692000"/>
                    <a:gd name="connsiteY84" fmla="*/ 316800 h 950400"/>
                    <a:gd name="connsiteX85" fmla="*/ 187200 w 1692000"/>
                    <a:gd name="connsiteY85" fmla="*/ 324000 h 950400"/>
                    <a:gd name="connsiteX86" fmla="*/ 86400 w 1692000"/>
                    <a:gd name="connsiteY86" fmla="*/ 316800 h 950400"/>
                    <a:gd name="connsiteX87" fmla="*/ 64800 w 1692000"/>
                    <a:gd name="connsiteY87" fmla="*/ 309600 h 950400"/>
                    <a:gd name="connsiteX88" fmla="*/ 0 w 1692000"/>
                    <a:gd name="connsiteY88" fmla="*/ 316800 h 950400"/>
                    <a:gd name="connsiteX89" fmla="*/ 7200 w 1692000"/>
                    <a:gd name="connsiteY89" fmla="*/ 345600 h 950400"/>
                    <a:gd name="connsiteX90" fmla="*/ 50400 w 1692000"/>
                    <a:gd name="connsiteY90" fmla="*/ 367200 h 950400"/>
                    <a:gd name="connsiteX91" fmla="*/ 208800 w 1692000"/>
                    <a:gd name="connsiteY91" fmla="*/ 352800 h 950400"/>
                    <a:gd name="connsiteX92" fmla="*/ 230400 w 1692000"/>
                    <a:gd name="connsiteY92" fmla="*/ 345600 h 950400"/>
                    <a:gd name="connsiteX93" fmla="*/ 288000 w 1692000"/>
                    <a:gd name="connsiteY93" fmla="*/ 331200 h 950400"/>
                    <a:gd name="connsiteX94" fmla="*/ 309600 w 1692000"/>
                    <a:gd name="connsiteY94" fmla="*/ 324000 h 950400"/>
                    <a:gd name="connsiteX95" fmla="*/ 345600 w 1692000"/>
                    <a:gd name="connsiteY95" fmla="*/ 316800 h 950400"/>
                    <a:gd name="connsiteX96" fmla="*/ 403200 w 1692000"/>
                    <a:gd name="connsiteY96" fmla="*/ 302400 h 950400"/>
                    <a:gd name="connsiteX97" fmla="*/ 489600 w 1692000"/>
                    <a:gd name="connsiteY97" fmla="*/ 280800 h 950400"/>
                    <a:gd name="connsiteX98" fmla="*/ 518400 w 1692000"/>
                    <a:gd name="connsiteY98" fmla="*/ 273600 h 950400"/>
                    <a:gd name="connsiteX99" fmla="*/ 547200 w 1692000"/>
                    <a:gd name="connsiteY99" fmla="*/ 266400 h 950400"/>
                    <a:gd name="connsiteX100" fmla="*/ 741600 w 1692000"/>
                    <a:gd name="connsiteY100" fmla="*/ 273600 h 950400"/>
                    <a:gd name="connsiteX101" fmla="*/ 806400 w 1692000"/>
                    <a:gd name="connsiteY101" fmla="*/ 295200 h 950400"/>
                    <a:gd name="connsiteX102" fmla="*/ 900000 w 1692000"/>
                    <a:gd name="connsiteY102" fmla="*/ 309600 h 950400"/>
                    <a:gd name="connsiteX103" fmla="*/ 928800 w 1692000"/>
                    <a:gd name="connsiteY103" fmla="*/ 316800 h 950400"/>
                    <a:gd name="connsiteX104" fmla="*/ 986400 w 1692000"/>
                    <a:gd name="connsiteY104" fmla="*/ 331200 h 950400"/>
                    <a:gd name="connsiteX105" fmla="*/ 1058400 w 1692000"/>
                    <a:gd name="connsiteY105" fmla="*/ 316800 h 950400"/>
                    <a:gd name="connsiteX106" fmla="*/ 1288800 w 1692000"/>
                    <a:gd name="connsiteY106" fmla="*/ 324000 h 9504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</a:cxnLst>
                  <a:rect l="l" t="t" r="r" b="b"/>
                  <a:pathLst>
                    <a:path w="1692000" h="950400">
                      <a:moveTo>
                        <a:pt x="1288800" y="324000"/>
                      </a:moveTo>
                      <a:lnTo>
                        <a:pt x="1288800" y="324000"/>
                      </a:lnTo>
                      <a:cubicBezTo>
                        <a:pt x="1305600" y="338400"/>
                        <a:pt x="1324248" y="350889"/>
                        <a:pt x="1339200" y="367200"/>
                      </a:cubicBezTo>
                      <a:cubicBezTo>
                        <a:pt x="1350895" y="379958"/>
                        <a:pt x="1358400" y="396000"/>
                        <a:pt x="1368000" y="410400"/>
                      </a:cubicBezTo>
                      <a:cubicBezTo>
                        <a:pt x="1372800" y="417600"/>
                        <a:pt x="1379664" y="423791"/>
                        <a:pt x="1382400" y="432000"/>
                      </a:cubicBezTo>
                      <a:cubicBezTo>
                        <a:pt x="1384800" y="439200"/>
                        <a:pt x="1386206" y="446812"/>
                        <a:pt x="1389600" y="453600"/>
                      </a:cubicBezTo>
                      <a:cubicBezTo>
                        <a:pt x="1393470" y="461340"/>
                        <a:pt x="1400130" y="467460"/>
                        <a:pt x="1404000" y="475200"/>
                      </a:cubicBezTo>
                      <a:cubicBezTo>
                        <a:pt x="1407394" y="481988"/>
                        <a:pt x="1407806" y="490012"/>
                        <a:pt x="1411200" y="496800"/>
                      </a:cubicBezTo>
                      <a:cubicBezTo>
                        <a:pt x="1415070" y="504540"/>
                        <a:pt x="1421730" y="510660"/>
                        <a:pt x="1425600" y="518400"/>
                      </a:cubicBezTo>
                      <a:cubicBezTo>
                        <a:pt x="1428994" y="525188"/>
                        <a:pt x="1429114" y="533366"/>
                        <a:pt x="1432800" y="540000"/>
                      </a:cubicBezTo>
                      <a:cubicBezTo>
                        <a:pt x="1441205" y="555129"/>
                        <a:pt x="1461600" y="583200"/>
                        <a:pt x="1461600" y="583200"/>
                      </a:cubicBezTo>
                      <a:cubicBezTo>
                        <a:pt x="1464000" y="595200"/>
                        <a:pt x="1464930" y="607590"/>
                        <a:pt x="1468800" y="619200"/>
                      </a:cubicBezTo>
                      <a:cubicBezTo>
                        <a:pt x="1472194" y="629382"/>
                        <a:pt x="1478972" y="638135"/>
                        <a:pt x="1483200" y="648000"/>
                      </a:cubicBezTo>
                      <a:cubicBezTo>
                        <a:pt x="1486190" y="654976"/>
                        <a:pt x="1488315" y="662303"/>
                        <a:pt x="1490400" y="669600"/>
                      </a:cubicBezTo>
                      <a:cubicBezTo>
                        <a:pt x="1495431" y="687209"/>
                        <a:pt x="1503445" y="728767"/>
                        <a:pt x="1512000" y="741600"/>
                      </a:cubicBezTo>
                      <a:cubicBezTo>
                        <a:pt x="1516800" y="748800"/>
                        <a:pt x="1522886" y="755292"/>
                        <a:pt x="1526400" y="763200"/>
                      </a:cubicBezTo>
                      <a:cubicBezTo>
                        <a:pt x="1532565" y="777071"/>
                        <a:pt x="1536000" y="792000"/>
                        <a:pt x="1540800" y="806400"/>
                      </a:cubicBezTo>
                      <a:lnTo>
                        <a:pt x="1562400" y="871200"/>
                      </a:lnTo>
                      <a:cubicBezTo>
                        <a:pt x="1568740" y="890219"/>
                        <a:pt x="1579832" y="929811"/>
                        <a:pt x="1598400" y="936000"/>
                      </a:cubicBezTo>
                      <a:lnTo>
                        <a:pt x="1641600" y="950400"/>
                      </a:lnTo>
                      <a:cubicBezTo>
                        <a:pt x="1685126" y="939519"/>
                        <a:pt x="1667271" y="952588"/>
                        <a:pt x="1684800" y="900000"/>
                      </a:cubicBezTo>
                      <a:lnTo>
                        <a:pt x="1692000" y="878400"/>
                      </a:lnTo>
                      <a:cubicBezTo>
                        <a:pt x="1689600" y="835200"/>
                        <a:pt x="1690167" y="791733"/>
                        <a:pt x="1684800" y="748800"/>
                      </a:cubicBezTo>
                      <a:cubicBezTo>
                        <a:pt x="1677344" y="689150"/>
                        <a:pt x="1673301" y="722928"/>
                        <a:pt x="1656000" y="684000"/>
                      </a:cubicBezTo>
                      <a:cubicBezTo>
                        <a:pt x="1649835" y="670129"/>
                        <a:pt x="1646400" y="655200"/>
                        <a:pt x="1641600" y="640800"/>
                      </a:cubicBezTo>
                      <a:lnTo>
                        <a:pt x="1627200" y="597600"/>
                      </a:lnTo>
                      <a:lnTo>
                        <a:pt x="1620000" y="576000"/>
                      </a:lnTo>
                      <a:lnTo>
                        <a:pt x="1612800" y="554400"/>
                      </a:lnTo>
                      <a:cubicBezTo>
                        <a:pt x="1610015" y="529338"/>
                        <a:pt x="1608218" y="471927"/>
                        <a:pt x="1591200" y="446400"/>
                      </a:cubicBezTo>
                      <a:lnTo>
                        <a:pt x="1576800" y="424800"/>
                      </a:lnTo>
                      <a:cubicBezTo>
                        <a:pt x="1574230" y="414518"/>
                        <a:pt x="1559981" y="354394"/>
                        <a:pt x="1555200" y="352800"/>
                      </a:cubicBezTo>
                      <a:cubicBezTo>
                        <a:pt x="1517181" y="340127"/>
                        <a:pt x="1539915" y="349810"/>
                        <a:pt x="1490400" y="316800"/>
                      </a:cubicBezTo>
                      <a:cubicBezTo>
                        <a:pt x="1483200" y="312000"/>
                        <a:pt x="1477009" y="305136"/>
                        <a:pt x="1468800" y="302400"/>
                      </a:cubicBezTo>
                      <a:cubicBezTo>
                        <a:pt x="1414508" y="284303"/>
                        <a:pt x="1481430" y="308715"/>
                        <a:pt x="1425600" y="280800"/>
                      </a:cubicBezTo>
                      <a:cubicBezTo>
                        <a:pt x="1418812" y="277406"/>
                        <a:pt x="1410634" y="277286"/>
                        <a:pt x="1404000" y="273600"/>
                      </a:cubicBezTo>
                      <a:cubicBezTo>
                        <a:pt x="1388871" y="265195"/>
                        <a:pt x="1377590" y="248997"/>
                        <a:pt x="1360800" y="244800"/>
                      </a:cubicBezTo>
                      <a:cubicBezTo>
                        <a:pt x="1354021" y="243105"/>
                        <a:pt x="1318851" y="235095"/>
                        <a:pt x="1310400" y="230400"/>
                      </a:cubicBezTo>
                      <a:cubicBezTo>
                        <a:pt x="1295271" y="221995"/>
                        <a:pt x="1283619" y="207073"/>
                        <a:pt x="1267200" y="201600"/>
                      </a:cubicBezTo>
                      <a:cubicBezTo>
                        <a:pt x="1212908" y="183503"/>
                        <a:pt x="1279830" y="207915"/>
                        <a:pt x="1224000" y="180000"/>
                      </a:cubicBezTo>
                      <a:cubicBezTo>
                        <a:pt x="1217212" y="176606"/>
                        <a:pt x="1209188" y="176194"/>
                        <a:pt x="1202400" y="172800"/>
                      </a:cubicBezTo>
                      <a:cubicBezTo>
                        <a:pt x="1194660" y="168930"/>
                        <a:pt x="1188540" y="162270"/>
                        <a:pt x="1180800" y="158400"/>
                      </a:cubicBezTo>
                      <a:cubicBezTo>
                        <a:pt x="1174012" y="155006"/>
                        <a:pt x="1165988" y="154594"/>
                        <a:pt x="1159200" y="151200"/>
                      </a:cubicBezTo>
                      <a:cubicBezTo>
                        <a:pt x="1151460" y="147330"/>
                        <a:pt x="1145340" y="140670"/>
                        <a:pt x="1137600" y="136800"/>
                      </a:cubicBezTo>
                      <a:cubicBezTo>
                        <a:pt x="1130812" y="133406"/>
                        <a:pt x="1122788" y="132994"/>
                        <a:pt x="1116000" y="129600"/>
                      </a:cubicBezTo>
                      <a:cubicBezTo>
                        <a:pt x="1108260" y="125730"/>
                        <a:pt x="1102308" y="118714"/>
                        <a:pt x="1094400" y="115200"/>
                      </a:cubicBezTo>
                      <a:cubicBezTo>
                        <a:pt x="1080529" y="109035"/>
                        <a:pt x="1065600" y="105600"/>
                        <a:pt x="1051200" y="100800"/>
                      </a:cubicBezTo>
                      <a:lnTo>
                        <a:pt x="1008000" y="86400"/>
                      </a:lnTo>
                      <a:cubicBezTo>
                        <a:pt x="1000800" y="84000"/>
                        <a:pt x="993842" y="80688"/>
                        <a:pt x="986400" y="79200"/>
                      </a:cubicBezTo>
                      <a:cubicBezTo>
                        <a:pt x="913208" y="64562"/>
                        <a:pt x="980459" y="79560"/>
                        <a:pt x="928800" y="64800"/>
                      </a:cubicBezTo>
                      <a:cubicBezTo>
                        <a:pt x="919285" y="62082"/>
                        <a:pt x="909478" y="60443"/>
                        <a:pt x="900000" y="57600"/>
                      </a:cubicBezTo>
                      <a:cubicBezTo>
                        <a:pt x="885461" y="53238"/>
                        <a:pt x="871200" y="48000"/>
                        <a:pt x="856800" y="43200"/>
                      </a:cubicBezTo>
                      <a:lnTo>
                        <a:pt x="813600" y="28800"/>
                      </a:lnTo>
                      <a:cubicBezTo>
                        <a:pt x="806400" y="26400"/>
                        <a:pt x="798315" y="25810"/>
                        <a:pt x="792000" y="21600"/>
                      </a:cubicBezTo>
                      <a:cubicBezTo>
                        <a:pt x="762166" y="1711"/>
                        <a:pt x="778795" y="9299"/>
                        <a:pt x="741600" y="0"/>
                      </a:cubicBezTo>
                      <a:cubicBezTo>
                        <a:pt x="724087" y="2919"/>
                        <a:pt x="685771" y="-3775"/>
                        <a:pt x="691200" y="28800"/>
                      </a:cubicBezTo>
                      <a:cubicBezTo>
                        <a:pt x="695614" y="55281"/>
                        <a:pt x="709842" y="48921"/>
                        <a:pt x="727200" y="57600"/>
                      </a:cubicBezTo>
                      <a:cubicBezTo>
                        <a:pt x="795659" y="91830"/>
                        <a:pt x="680548" y="49249"/>
                        <a:pt x="792000" y="86400"/>
                      </a:cubicBezTo>
                      <a:lnTo>
                        <a:pt x="900000" y="122400"/>
                      </a:lnTo>
                      <a:lnTo>
                        <a:pt x="921600" y="129600"/>
                      </a:lnTo>
                      <a:cubicBezTo>
                        <a:pt x="928800" y="132000"/>
                        <a:pt x="936885" y="132590"/>
                        <a:pt x="943200" y="136800"/>
                      </a:cubicBezTo>
                      <a:cubicBezTo>
                        <a:pt x="950400" y="141600"/>
                        <a:pt x="957060" y="147330"/>
                        <a:pt x="964800" y="151200"/>
                      </a:cubicBezTo>
                      <a:cubicBezTo>
                        <a:pt x="971588" y="154594"/>
                        <a:pt x="979766" y="154714"/>
                        <a:pt x="986400" y="158400"/>
                      </a:cubicBezTo>
                      <a:lnTo>
                        <a:pt x="1051200" y="201600"/>
                      </a:lnTo>
                      <a:cubicBezTo>
                        <a:pt x="1058400" y="206400"/>
                        <a:pt x="1064591" y="213264"/>
                        <a:pt x="1072800" y="216000"/>
                      </a:cubicBezTo>
                      <a:lnTo>
                        <a:pt x="1094400" y="223200"/>
                      </a:lnTo>
                      <a:cubicBezTo>
                        <a:pt x="1101600" y="230400"/>
                        <a:pt x="1116000" y="234618"/>
                        <a:pt x="1116000" y="244800"/>
                      </a:cubicBezTo>
                      <a:cubicBezTo>
                        <a:pt x="1116000" y="252389"/>
                        <a:pt x="1101989" y="252000"/>
                        <a:pt x="1094400" y="252000"/>
                      </a:cubicBezTo>
                      <a:cubicBezTo>
                        <a:pt x="1051133" y="252000"/>
                        <a:pt x="1008000" y="247200"/>
                        <a:pt x="964800" y="244800"/>
                      </a:cubicBezTo>
                      <a:lnTo>
                        <a:pt x="921600" y="230400"/>
                      </a:lnTo>
                      <a:cubicBezTo>
                        <a:pt x="914400" y="228000"/>
                        <a:pt x="906315" y="227410"/>
                        <a:pt x="900000" y="223200"/>
                      </a:cubicBezTo>
                      <a:cubicBezTo>
                        <a:pt x="892800" y="218400"/>
                        <a:pt x="886609" y="211536"/>
                        <a:pt x="878400" y="208800"/>
                      </a:cubicBezTo>
                      <a:cubicBezTo>
                        <a:pt x="856729" y="201576"/>
                        <a:pt x="763165" y="195051"/>
                        <a:pt x="756000" y="194400"/>
                      </a:cubicBezTo>
                      <a:cubicBezTo>
                        <a:pt x="712474" y="183519"/>
                        <a:pt x="736588" y="190329"/>
                        <a:pt x="684000" y="172800"/>
                      </a:cubicBezTo>
                      <a:lnTo>
                        <a:pt x="662400" y="165600"/>
                      </a:lnTo>
                      <a:cubicBezTo>
                        <a:pt x="655200" y="163200"/>
                        <a:pt x="647115" y="162610"/>
                        <a:pt x="640800" y="158400"/>
                      </a:cubicBezTo>
                      <a:cubicBezTo>
                        <a:pt x="609018" y="137212"/>
                        <a:pt x="627685" y="145697"/>
                        <a:pt x="583200" y="136800"/>
                      </a:cubicBezTo>
                      <a:cubicBezTo>
                        <a:pt x="573226" y="138795"/>
                        <a:pt x="538054" y="144281"/>
                        <a:pt x="525600" y="151200"/>
                      </a:cubicBezTo>
                      <a:cubicBezTo>
                        <a:pt x="510471" y="159605"/>
                        <a:pt x="496800" y="170400"/>
                        <a:pt x="482400" y="180000"/>
                      </a:cubicBezTo>
                      <a:lnTo>
                        <a:pt x="460800" y="194400"/>
                      </a:lnTo>
                      <a:cubicBezTo>
                        <a:pt x="436800" y="230400"/>
                        <a:pt x="453600" y="211200"/>
                        <a:pt x="403200" y="244800"/>
                      </a:cubicBezTo>
                      <a:lnTo>
                        <a:pt x="381600" y="259200"/>
                      </a:lnTo>
                      <a:cubicBezTo>
                        <a:pt x="374400" y="264000"/>
                        <a:pt x="368209" y="270864"/>
                        <a:pt x="360000" y="273600"/>
                      </a:cubicBezTo>
                      <a:lnTo>
                        <a:pt x="295200" y="295200"/>
                      </a:lnTo>
                      <a:cubicBezTo>
                        <a:pt x="288000" y="297600"/>
                        <a:pt x="280963" y="300559"/>
                        <a:pt x="273600" y="302400"/>
                      </a:cubicBezTo>
                      <a:lnTo>
                        <a:pt x="216000" y="316800"/>
                      </a:lnTo>
                      <a:lnTo>
                        <a:pt x="187200" y="324000"/>
                      </a:lnTo>
                      <a:cubicBezTo>
                        <a:pt x="153600" y="321600"/>
                        <a:pt x="119855" y="320736"/>
                        <a:pt x="86400" y="316800"/>
                      </a:cubicBezTo>
                      <a:cubicBezTo>
                        <a:pt x="78863" y="315913"/>
                        <a:pt x="72389" y="309600"/>
                        <a:pt x="64800" y="309600"/>
                      </a:cubicBezTo>
                      <a:cubicBezTo>
                        <a:pt x="43067" y="309600"/>
                        <a:pt x="21600" y="314400"/>
                        <a:pt x="0" y="316800"/>
                      </a:cubicBezTo>
                      <a:cubicBezTo>
                        <a:pt x="2400" y="326400"/>
                        <a:pt x="1711" y="337366"/>
                        <a:pt x="7200" y="345600"/>
                      </a:cubicBezTo>
                      <a:cubicBezTo>
                        <a:pt x="15176" y="357563"/>
                        <a:pt x="38079" y="363093"/>
                        <a:pt x="50400" y="367200"/>
                      </a:cubicBezTo>
                      <a:cubicBezTo>
                        <a:pt x="105779" y="363739"/>
                        <a:pt x="155875" y="364561"/>
                        <a:pt x="208800" y="352800"/>
                      </a:cubicBezTo>
                      <a:cubicBezTo>
                        <a:pt x="216209" y="351154"/>
                        <a:pt x="223078" y="347597"/>
                        <a:pt x="230400" y="345600"/>
                      </a:cubicBezTo>
                      <a:cubicBezTo>
                        <a:pt x="249494" y="340393"/>
                        <a:pt x="269225" y="337458"/>
                        <a:pt x="288000" y="331200"/>
                      </a:cubicBezTo>
                      <a:cubicBezTo>
                        <a:pt x="295200" y="328800"/>
                        <a:pt x="302237" y="325841"/>
                        <a:pt x="309600" y="324000"/>
                      </a:cubicBezTo>
                      <a:cubicBezTo>
                        <a:pt x="321472" y="321032"/>
                        <a:pt x="333676" y="319552"/>
                        <a:pt x="345600" y="316800"/>
                      </a:cubicBezTo>
                      <a:cubicBezTo>
                        <a:pt x="364884" y="312350"/>
                        <a:pt x="384000" y="307200"/>
                        <a:pt x="403200" y="302400"/>
                      </a:cubicBezTo>
                      <a:lnTo>
                        <a:pt x="489600" y="280800"/>
                      </a:lnTo>
                      <a:lnTo>
                        <a:pt x="518400" y="273600"/>
                      </a:lnTo>
                      <a:lnTo>
                        <a:pt x="547200" y="266400"/>
                      </a:lnTo>
                      <a:cubicBezTo>
                        <a:pt x="612000" y="268800"/>
                        <a:pt x="677022" y="267729"/>
                        <a:pt x="741600" y="273600"/>
                      </a:cubicBezTo>
                      <a:cubicBezTo>
                        <a:pt x="768000" y="276000"/>
                        <a:pt x="782400" y="290400"/>
                        <a:pt x="806400" y="295200"/>
                      </a:cubicBezTo>
                      <a:cubicBezTo>
                        <a:pt x="916510" y="317222"/>
                        <a:pt x="743078" y="283446"/>
                        <a:pt x="900000" y="309600"/>
                      </a:cubicBezTo>
                      <a:cubicBezTo>
                        <a:pt x="909761" y="311227"/>
                        <a:pt x="919140" y="314653"/>
                        <a:pt x="928800" y="316800"/>
                      </a:cubicBezTo>
                      <a:cubicBezTo>
                        <a:pt x="980931" y="328385"/>
                        <a:pt x="947802" y="318334"/>
                        <a:pt x="986400" y="331200"/>
                      </a:cubicBezTo>
                      <a:cubicBezTo>
                        <a:pt x="1005430" y="326442"/>
                        <a:pt x="1040746" y="316800"/>
                        <a:pt x="1058400" y="316800"/>
                      </a:cubicBezTo>
                      <a:cubicBezTo>
                        <a:pt x="1128041" y="316800"/>
                        <a:pt x="1250400" y="322800"/>
                        <a:pt x="1288800" y="32400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9" name="Freeform 8">
                  <a:extLst>
                    <a:ext uri="{FF2B5EF4-FFF2-40B4-BE49-F238E27FC236}">
                      <a16:creationId xmlns:a16="http://schemas.microsoft.com/office/drawing/2014/main" id="{405AB5C5-C877-98AF-360D-25D4E483936B}"/>
                    </a:ext>
                  </a:extLst>
                </p:cNvPr>
                <p:cNvSpPr/>
                <p:nvPr/>
              </p:nvSpPr>
              <p:spPr>
                <a:xfrm>
                  <a:off x="10672926" y="1379738"/>
                  <a:ext cx="357124" cy="504175"/>
                </a:xfrm>
                <a:custGeom>
                  <a:avLst/>
                  <a:gdLst>
                    <a:gd name="connsiteX0" fmla="*/ 14400 w 489600"/>
                    <a:gd name="connsiteY0" fmla="*/ 28800 h 691200"/>
                    <a:gd name="connsiteX1" fmla="*/ 14400 w 489600"/>
                    <a:gd name="connsiteY1" fmla="*/ 28800 h 691200"/>
                    <a:gd name="connsiteX2" fmla="*/ 7200 w 489600"/>
                    <a:gd name="connsiteY2" fmla="*/ 93600 h 691200"/>
                    <a:gd name="connsiteX3" fmla="*/ 0 w 489600"/>
                    <a:gd name="connsiteY3" fmla="*/ 115200 h 691200"/>
                    <a:gd name="connsiteX4" fmla="*/ 7200 w 489600"/>
                    <a:gd name="connsiteY4" fmla="*/ 244800 h 691200"/>
                    <a:gd name="connsiteX5" fmla="*/ 21600 w 489600"/>
                    <a:gd name="connsiteY5" fmla="*/ 288000 h 691200"/>
                    <a:gd name="connsiteX6" fmla="*/ 64800 w 489600"/>
                    <a:gd name="connsiteY6" fmla="*/ 316800 h 691200"/>
                    <a:gd name="connsiteX7" fmla="*/ 93600 w 489600"/>
                    <a:gd name="connsiteY7" fmla="*/ 360000 h 691200"/>
                    <a:gd name="connsiteX8" fmla="*/ 115200 w 489600"/>
                    <a:gd name="connsiteY8" fmla="*/ 424800 h 691200"/>
                    <a:gd name="connsiteX9" fmla="*/ 122400 w 489600"/>
                    <a:gd name="connsiteY9" fmla="*/ 446400 h 691200"/>
                    <a:gd name="connsiteX10" fmla="*/ 136800 w 489600"/>
                    <a:gd name="connsiteY10" fmla="*/ 468000 h 691200"/>
                    <a:gd name="connsiteX11" fmla="*/ 151200 w 489600"/>
                    <a:gd name="connsiteY11" fmla="*/ 525600 h 691200"/>
                    <a:gd name="connsiteX12" fmla="*/ 158400 w 489600"/>
                    <a:gd name="connsiteY12" fmla="*/ 547200 h 691200"/>
                    <a:gd name="connsiteX13" fmla="*/ 223200 w 489600"/>
                    <a:gd name="connsiteY13" fmla="*/ 590400 h 691200"/>
                    <a:gd name="connsiteX14" fmla="*/ 244800 w 489600"/>
                    <a:gd name="connsiteY14" fmla="*/ 604800 h 691200"/>
                    <a:gd name="connsiteX15" fmla="*/ 259200 w 489600"/>
                    <a:gd name="connsiteY15" fmla="*/ 626400 h 691200"/>
                    <a:gd name="connsiteX16" fmla="*/ 280800 w 489600"/>
                    <a:gd name="connsiteY16" fmla="*/ 669600 h 691200"/>
                    <a:gd name="connsiteX17" fmla="*/ 324000 w 489600"/>
                    <a:gd name="connsiteY17" fmla="*/ 691200 h 691200"/>
                    <a:gd name="connsiteX18" fmla="*/ 374400 w 489600"/>
                    <a:gd name="connsiteY18" fmla="*/ 684000 h 691200"/>
                    <a:gd name="connsiteX19" fmla="*/ 403200 w 489600"/>
                    <a:gd name="connsiteY19" fmla="*/ 640800 h 691200"/>
                    <a:gd name="connsiteX20" fmla="*/ 432000 w 489600"/>
                    <a:gd name="connsiteY20" fmla="*/ 633600 h 691200"/>
                    <a:gd name="connsiteX21" fmla="*/ 475200 w 489600"/>
                    <a:gd name="connsiteY21" fmla="*/ 626400 h 691200"/>
                    <a:gd name="connsiteX22" fmla="*/ 489600 w 489600"/>
                    <a:gd name="connsiteY22" fmla="*/ 583200 h 691200"/>
                    <a:gd name="connsiteX23" fmla="*/ 482400 w 489600"/>
                    <a:gd name="connsiteY23" fmla="*/ 525600 h 691200"/>
                    <a:gd name="connsiteX24" fmla="*/ 424800 w 489600"/>
                    <a:gd name="connsiteY24" fmla="*/ 489600 h 691200"/>
                    <a:gd name="connsiteX25" fmla="*/ 381600 w 489600"/>
                    <a:gd name="connsiteY25" fmla="*/ 468000 h 691200"/>
                    <a:gd name="connsiteX26" fmla="*/ 352800 w 489600"/>
                    <a:gd name="connsiteY26" fmla="*/ 424800 h 691200"/>
                    <a:gd name="connsiteX27" fmla="*/ 345600 w 489600"/>
                    <a:gd name="connsiteY27" fmla="*/ 403200 h 691200"/>
                    <a:gd name="connsiteX28" fmla="*/ 331200 w 489600"/>
                    <a:gd name="connsiteY28" fmla="*/ 381600 h 691200"/>
                    <a:gd name="connsiteX29" fmla="*/ 324000 w 489600"/>
                    <a:gd name="connsiteY29" fmla="*/ 360000 h 691200"/>
                    <a:gd name="connsiteX30" fmla="*/ 295200 w 489600"/>
                    <a:gd name="connsiteY30" fmla="*/ 316800 h 691200"/>
                    <a:gd name="connsiteX31" fmla="*/ 280800 w 489600"/>
                    <a:gd name="connsiteY31" fmla="*/ 295200 h 691200"/>
                    <a:gd name="connsiteX32" fmla="*/ 244800 w 489600"/>
                    <a:gd name="connsiteY32" fmla="*/ 230400 h 691200"/>
                    <a:gd name="connsiteX33" fmla="*/ 230400 w 489600"/>
                    <a:gd name="connsiteY33" fmla="*/ 208800 h 691200"/>
                    <a:gd name="connsiteX34" fmla="*/ 216000 w 489600"/>
                    <a:gd name="connsiteY34" fmla="*/ 187200 h 691200"/>
                    <a:gd name="connsiteX35" fmla="*/ 201600 w 489600"/>
                    <a:gd name="connsiteY35" fmla="*/ 144000 h 691200"/>
                    <a:gd name="connsiteX36" fmla="*/ 194400 w 489600"/>
                    <a:gd name="connsiteY36" fmla="*/ 115200 h 691200"/>
                    <a:gd name="connsiteX37" fmla="*/ 165600 w 489600"/>
                    <a:gd name="connsiteY37" fmla="*/ 50400 h 691200"/>
                    <a:gd name="connsiteX38" fmla="*/ 144000 w 489600"/>
                    <a:gd name="connsiteY38" fmla="*/ 28800 h 691200"/>
                    <a:gd name="connsiteX39" fmla="*/ 100800 w 489600"/>
                    <a:gd name="connsiteY39" fmla="*/ 0 h 691200"/>
                    <a:gd name="connsiteX40" fmla="*/ 21600 w 489600"/>
                    <a:gd name="connsiteY40" fmla="*/ 21600 h 691200"/>
                    <a:gd name="connsiteX41" fmla="*/ 14400 w 489600"/>
                    <a:gd name="connsiteY41" fmla="*/ 28800 h 6912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</a:cxnLst>
                  <a:rect l="l" t="t" r="r" b="b"/>
                  <a:pathLst>
                    <a:path w="489600" h="691200">
                      <a:moveTo>
                        <a:pt x="14400" y="28800"/>
                      </a:moveTo>
                      <a:lnTo>
                        <a:pt x="14400" y="28800"/>
                      </a:lnTo>
                      <a:cubicBezTo>
                        <a:pt x="12000" y="50400"/>
                        <a:pt x="10773" y="72163"/>
                        <a:pt x="7200" y="93600"/>
                      </a:cubicBezTo>
                      <a:cubicBezTo>
                        <a:pt x="5952" y="101086"/>
                        <a:pt x="0" y="107611"/>
                        <a:pt x="0" y="115200"/>
                      </a:cubicBezTo>
                      <a:cubicBezTo>
                        <a:pt x="0" y="158467"/>
                        <a:pt x="1833" y="201867"/>
                        <a:pt x="7200" y="244800"/>
                      </a:cubicBezTo>
                      <a:cubicBezTo>
                        <a:pt x="9083" y="259862"/>
                        <a:pt x="8970" y="279580"/>
                        <a:pt x="21600" y="288000"/>
                      </a:cubicBezTo>
                      <a:lnTo>
                        <a:pt x="64800" y="316800"/>
                      </a:lnTo>
                      <a:cubicBezTo>
                        <a:pt x="74400" y="331200"/>
                        <a:pt x="88127" y="343581"/>
                        <a:pt x="93600" y="360000"/>
                      </a:cubicBezTo>
                      <a:lnTo>
                        <a:pt x="115200" y="424800"/>
                      </a:lnTo>
                      <a:cubicBezTo>
                        <a:pt x="117600" y="432000"/>
                        <a:pt x="118190" y="440085"/>
                        <a:pt x="122400" y="446400"/>
                      </a:cubicBezTo>
                      <a:lnTo>
                        <a:pt x="136800" y="468000"/>
                      </a:lnTo>
                      <a:cubicBezTo>
                        <a:pt x="141600" y="487200"/>
                        <a:pt x="144942" y="506825"/>
                        <a:pt x="151200" y="525600"/>
                      </a:cubicBezTo>
                      <a:cubicBezTo>
                        <a:pt x="153600" y="532800"/>
                        <a:pt x="153033" y="541833"/>
                        <a:pt x="158400" y="547200"/>
                      </a:cubicBezTo>
                      <a:lnTo>
                        <a:pt x="223200" y="590400"/>
                      </a:lnTo>
                      <a:lnTo>
                        <a:pt x="244800" y="604800"/>
                      </a:lnTo>
                      <a:cubicBezTo>
                        <a:pt x="249600" y="612000"/>
                        <a:pt x="255330" y="618660"/>
                        <a:pt x="259200" y="626400"/>
                      </a:cubicBezTo>
                      <a:cubicBezTo>
                        <a:pt x="270912" y="649824"/>
                        <a:pt x="260166" y="648966"/>
                        <a:pt x="280800" y="669600"/>
                      </a:cubicBezTo>
                      <a:cubicBezTo>
                        <a:pt x="294757" y="683557"/>
                        <a:pt x="306432" y="685344"/>
                        <a:pt x="324000" y="691200"/>
                      </a:cubicBezTo>
                      <a:cubicBezTo>
                        <a:pt x="340800" y="688800"/>
                        <a:pt x="362400" y="696000"/>
                        <a:pt x="374400" y="684000"/>
                      </a:cubicBezTo>
                      <a:cubicBezTo>
                        <a:pt x="419903" y="638497"/>
                        <a:pt x="348851" y="622684"/>
                        <a:pt x="403200" y="640800"/>
                      </a:cubicBezTo>
                      <a:cubicBezTo>
                        <a:pt x="412800" y="638400"/>
                        <a:pt x="422297" y="635541"/>
                        <a:pt x="432000" y="633600"/>
                      </a:cubicBezTo>
                      <a:cubicBezTo>
                        <a:pt x="446315" y="630737"/>
                        <a:pt x="464213" y="636013"/>
                        <a:pt x="475200" y="626400"/>
                      </a:cubicBezTo>
                      <a:cubicBezTo>
                        <a:pt x="486623" y="616405"/>
                        <a:pt x="489600" y="583200"/>
                        <a:pt x="489600" y="583200"/>
                      </a:cubicBezTo>
                      <a:cubicBezTo>
                        <a:pt x="487200" y="564000"/>
                        <a:pt x="487491" y="544268"/>
                        <a:pt x="482400" y="525600"/>
                      </a:cubicBezTo>
                      <a:cubicBezTo>
                        <a:pt x="474413" y="496315"/>
                        <a:pt x="450191" y="498064"/>
                        <a:pt x="424800" y="489600"/>
                      </a:cubicBezTo>
                      <a:cubicBezTo>
                        <a:pt x="394991" y="479664"/>
                        <a:pt x="409515" y="486610"/>
                        <a:pt x="381600" y="468000"/>
                      </a:cubicBezTo>
                      <a:cubicBezTo>
                        <a:pt x="372000" y="453600"/>
                        <a:pt x="358273" y="441219"/>
                        <a:pt x="352800" y="424800"/>
                      </a:cubicBezTo>
                      <a:cubicBezTo>
                        <a:pt x="350400" y="417600"/>
                        <a:pt x="348994" y="409988"/>
                        <a:pt x="345600" y="403200"/>
                      </a:cubicBezTo>
                      <a:cubicBezTo>
                        <a:pt x="341730" y="395460"/>
                        <a:pt x="335070" y="389340"/>
                        <a:pt x="331200" y="381600"/>
                      </a:cubicBezTo>
                      <a:cubicBezTo>
                        <a:pt x="327806" y="374812"/>
                        <a:pt x="327686" y="366634"/>
                        <a:pt x="324000" y="360000"/>
                      </a:cubicBezTo>
                      <a:cubicBezTo>
                        <a:pt x="315595" y="344871"/>
                        <a:pt x="304800" y="331200"/>
                        <a:pt x="295200" y="316800"/>
                      </a:cubicBezTo>
                      <a:cubicBezTo>
                        <a:pt x="290400" y="309600"/>
                        <a:pt x="283536" y="303409"/>
                        <a:pt x="280800" y="295200"/>
                      </a:cubicBezTo>
                      <a:cubicBezTo>
                        <a:pt x="268127" y="257181"/>
                        <a:pt x="277810" y="279915"/>
                        <a:pt x="244800" y="230400"/>
                      </a:cubicBezTo>
                      <a:lnTo>
                        <a:pt x="230400" y="208800"/>
                      </a:lnTo>
                      <a:cubicBezTo>
                        <a:pt x="225600" y="201600"/>
                        <a:pt x="218736" y="195409"/>
                        <a:pt x="216000" y="187200"/>
                      </a:cubicBezTo>
                      <a:cubicBezTo>
                        <a:pt x="211200" y="172800"/>
                        <a:pt x="205281" y="158726"/>
                        <a:pt x="201600" y="144000"/>
                      </a:cubicBezTo>
                      <a:cubicBezTo>
                        <a:pt x="199200" y="134400"/>
                        <a:pt x="197243" y="124678"/>
                        <a:pt x="194400" y="115200"/>
                      </a:cubicBezTo>
                      <a:cubicBezTo>
                        <a:pt x="185570" y="85767"/>
                        <a:pt x="183684" y="72101"/>
                        <a:pt x="165600" y="50400"/>
                      </a:cubicBezTo>
                      <a:cubicBezTo>
                        <a:pt x="159081" y="42578"/>
                        <a:pt x="152037" y="35051"/>
                        <a:pt x="144000" y="28800"/>
                      </a:cubicBezTo>
                      <a:cubicBezTo>
                        <a:pt x="130339" y="18175"/>
                        <a:pt x="100800" y="0"/>
                        <a:pt x="100800" y="0"/>
                      </a:cubicBezTo>
                      <a:cubicBezTo>
                        <a:pt x="78324" y="2809"/>
                        <a:pt x="39752" y="-1090"/>
                        <a:pt x="21600" y="21600"/>
                      </a:cubicBezTo>
                      <a:cubicBezTo>
                        <a:pt x="13641" y="31549"/>
                        <a:pt x="15600" y="27600"/>
                        <a:pt x="14400" y="2880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0" name="Freeform 9">
                  <a:extLst>
                    <a:ext uri="{FF2B5EF4-FFF2-40B4-BE49-F238E27FC236}">
                      <a16:creationId xmlns:a16="http://schemas.microsoft.com/office/drawing/2014/main" id="{161C666B-406C-1E66-BA07-329F2329F9A7}"/>
                    </a:ext>
                  </a:extLst>
                </p:cNvPr>
                <p:cNvSpPr/>
                <p:nvPr/>
              </p:nvSpPr>
              <p:spPr>
                <a:xfrm>
                  <a:off x="12175600" y="4721842"/>
                  <a:ext cx="186755" cy="213434"/>
                </a:xfrm>
                <a:custGeom>
                  <a:avLst/>
                  <a:gdLst>
                    <a:gd name="connsiteX0" fmla="*/ 0 w 256032"/>
                    <a:gd name="connsiteY0" fmla="*/ 18288 h 292608"/>
                    <a:gd name="connsiteX1" fmla="*/ 0 w 256032"/>
                    <a:gd name="connsiteY1" fmla="*/ 18288 h 292608"/>
                    <a:gd name="connsiteX2" fmla="*/ 18288 w 256032"/>
                    <a:gd name="connsiteY2" fmla="*/ 146304 h 292608"/>
                    <a:gd name="connsiteX3" fmla="*/ 36576 w 256032"/>
                    <a:gd name="connsiteY3" fmla="*/ 201168 h 292608"/>
                    <a:gd name="connsiteX4" fmla="*/ 64008 w 256032"/>
                    <a:gd name="connsiteY4" fmla="*/ 219456 h 292608"/>
                    <a:gd name="connsiteX5" fmla="*/ 82296 w 256032"/>
                    <a:gd name="connsiteY5" fmla="*/ 246888 h 292608"/>
                    <a:gd name="connsiteX6" fmla="*/ 164592 w 256032"/>
                    <a:gd name="connsiteY6" fmla="*/ 283464 h 292608"/>
                    <a:gd name="connsiteX7" fmla="*/ 192024 w 256032"/>
                    <a:gd name="connsiteY7" fmla="*/ 292608 h 292608"/>
                    <a:gd name="connsiteX8" fmla="*/ 246888 w 256032"/>
                    <a:gd name="connsiteY8" fmla="*/ 283464 h 292608"/>
                    <a:gd name="connsiteX9" fmla="*/ 256032 w 256032"/>
                    <a:gd name="connsiteY9" fmla="*/ 256032 h 292608"/>
                    <a:gd name="connsiteX10" fmla="*/ 246888 w 256032"/>
                    <a:gd name="connsiteY10" fmla="*/ 192024 h 292608"/>
                    <a:gd name="connsiteX11" fmla="*/ 219456 w 256032"/>
                    <a:gd name="connsiteY11" fmla="*/ 137160 h 292608"/>
                    <a:gd name="connsiteX12" fmla="*/ 192024 w 256032"/>
                    <a:gd name="connsiteY12" fmla="*/ 118872 h 292608"/>
                    <a:gd name="connsiteX13" fmla="*/ 173736 w 256032"/>
                    <a:gd name="connsiteY13" fmla="*/ 91440 h 292608"/>
                    <a:gd name="connsiteX14" fmla="*/ 137160 w 256032"/>
                    <a:gd name="connsiteY14" fmla="*/ 36576 h 292608"/>
                    <a:gd name="connsiteX15" fmla="*/ 82296 w 256032"/>
                    <a:gd name="connsiteY15" fmla="*/ 0 h 292608"/>
                    <a:gd name="connsiteX16" fmla="*/ 0 w 256032"/>
                    <a:gd name="connsiteY16" fmla="*/ 18288 h 29260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</a:cxnLst>
                  <a:rect l="l" t="t" r="r" b="b"/>
                  <a:pathLst>
                    <a:path w="256032" h="292608">
                      <a:moveTo>
                        <a:pt x="0" y="18288"/>
                      </a:moveTo>
                      <a:lnTo>
                        <a:pt x="0" y="18288"/>
                      </a:lnTo>
                      <a:cubicBezTo>
                        <a:pt x="4397" y="57864"/>
                        <a:pt x="7370" y="106272"/>
                        <a:pt x="18288" y="146304"/>
                      </a:cubicBezTo>
                      <a:cubicBezTo>
                        <a:pt x="23360" y="164902"/>
                        <a:pt x="20536" y="190475"/>
                        <a:pt x="36576" y="201168"/>
                      </a:cubicBezTo>
                      <a:lnTo>
                        <a:pt x="64008" y="219456"/>
                      </a:lnTo>
                      <a:cubicBezTo>
                        <a:pt x="70104" y="228600"/>
                        <a:pt x="74525" y="239117"/>
                        <a:pt x="82296" y="246888"/>
                      </a:cubicBezTo>
                      <a:cubicBezTo>
                        <a:pt x="104032" y="268624"/>
                        <a:pt x="137429" y="274410"/>
                        <a:pt x="164592" y="283464"/>
                      </a:cubicBezTo>
                      <a:lnTo>
                        <a:pt x="192024" y="292608"/>
                      </a:lnTo>
                      <a:cubicBezTo>
                        <a:pt x="210312" y="289560"/>
                        <a:pt x="230791" y="292663"/>
                        <a:pt x="246888" y="283464"/>
                      </a:cubicBezTo>
                      <a:cubicBezTo>
                        <a:pt x="255257" y="278682"/>
                        <a:pt x="256032" y="265671"/>
                        <a:pt x="256032" y="256032"/>
                      </a:cubicBezTo>
                      <a:cubicBezTo>
                        <a:pt x="256032" y="234479"/>
                        <a:pt x="251115" y="213158"/>
                        <a:pt x="246888" y="192024"/>
                      </a:cubicBezTo>
                      <a:cubicBezTo>
                        <a:pt x="243169" y="173431"/>
                        <a:pt x="232942" y="150646"/>
                        <a:pt x="219456" y="137160"/>
                      </a:cubicBezTo>
                      <a:cubicBezTo>
                        <a:pt x="211685" y="129389"/>
                        <a:pt x="201168" y="124968"/>
                        <a:pt x="192024" y="118872"/>
                      </a:cubicBezTo>
                      <a:cubicBezTo>
                        <a:pt x="185928" y="109728"/>
                        <a:pt x="178651" y="101270"/>
                        <a:pt x="173736" y="91440"/>
                      </a:cubicBezTo>
                      <a:cubicBezTo>
                        <a:pt x="154317" y="52601"/>
                        <a:pt x="179707" y="69668"/>
                        <a:pt x="137160" y="36576"/>
                      </a:cubicBezTo>
                      <a:cubicBezTo>
                        <a:pt x="119810" y="23082"/>
                        <a:pt x="82296" y="0"/>
                        <a:pt x="82296" y="0"/>
                      </a:cubicBezTo>
                      <a:lnTo>
                        <a:pt x="0" y="18288"/>
                      </a:ln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" name="Freeform 10">
                  <a:extLst>
                    <a:ext uri="{FF2B5EF4-FFF2-40B4-BE49-F238E27FC236}">
                      <a16:creationId xmlns:a16="http://schemas.microsoft.com/office/drawing/2014/main" id="{C62B717B-FC36-4E49-8B62-970D8042E0F2}"/>
                    </a:ext>
                  </a:extLst>
                </p:cNvPr>
                <p:cNvSpPr/>
                <p:nvPr/>
              </p:nvSpPr>
              <p:spPr>
                <a:xfrm rot="21127171">
                  <a:off x="10708017" y="3828086"/>
                  <a:ext cx="433753" cy="380180"/>
                </a:xfrm>
                <a:custGeom>
                  <a:avLst/>
                  <a:gdLst>
                    <a:gd name="connsiteX0" fmla="*/ 46014 w 594654"/>
                    <a:gd name="connsiteY0" fmla="*/ 521208 h 521208"/>
                    <a:gd name="connsiteX1" fmla="*/ 46014 w 594654"/>
                    <a:gd name="connsiteY1" fmla="*/ 521208 h 521208"/>
                    <a:gd name="connsiteX2" fmla="*/ 137454 w 594654"/>
                    <a:gd name="connsiteY2" fmla="*/ 457200 h 521208"/>
                    <a:gd name="connsiteX3" fmla="*/ 192318 w 594654"/>
                    <a:gd name="connsiteY3" fmla="*/ 438912 h 521208"/>
                    <a:gd name="connsiteX4" fmla="*/ 219750 w 594654"/>
                    <a:gd name="connsiteY4" fmla="*/ 429768 h 521208"/>
                    <a:gd name="connsiteX5" fmla="*/ 247182 w 594654"/>
                    <a:gd name="connsiteY5" fmla="*/ 411480 h 521208"/>
                    <a:gd name="connsiteX6" fmla="*/ 274614 w 594654"/>
                    <a:gd name="connsiteY6" fmla="*/ 402336 h 521208"/>
                    <a:gd name="connsiteX7" fmla="*/ 356910 w 594654"/>
                    <a:gd name="connsiteY7" fmla="*/ 347472 h 521208"/>
                    <a:gd name="connsiteX8" fmla="*/ 384342 w 594654"/>
                    <a:gd name="connsiteY8" fmla="*/ 329184 h 521208"/>
                    <a:gd name="connsiteX9" fmla="*/ 411774 w 594654"/>
                    <a:gd name="connsiteY9" fmla="*/ 310896 h 521208"/>
                    <a:gd name="connsiteX10" fmla="*/ 430062 w 594654"/>
                    <a:gd name="connsiteY10" fmla="*/ 283464 h 521208"/>
                    <a:gd name="connsiteX11" fmla="*/ 484926 w 594654"/>
                    <a:gd name="connsiteY11" fmla="*/ 265176 h 521208"/>
                    <a:gd name="connsiteX12" fmla="*/ 512358 w 594654"/>
                    <a:gd name="connsiteY12" fmla="*/ 246888 h 521208"/>
                    <a:gd name="connsiteX13" fmla="*/ 558078 w 594654"/>
                    <a:gd name="connsiteY13" fmla="*/ 192024 h 521208"/>
                    <a:gd name="connsiteX14" fmla="*/ 594654 w 594654"/>
                    <a:gd name="connsiteY14" fmla="*/ 137160 h 521208"/>
                    <a:gd name="connsiteX15" fmla="*/ 585510 w 594654"/>
                    <a:gd name="connsiteY15" fmla="*/ 100584 h 521208"/>
                    <a:gd name="connsiteX16" fmla="*/ 475782 w 594654"/>
                    <a:gd name="connsiteY16" fmla="*/ 45720 h 521208"/>
                    <a:gd name="connsiteX17" fmla="*/ 448350 w 594654"/>
                    <a:gd name="connsiteY17" fmla="*/ 27432 h 521208"/>
                    <a:gd name="connsiteX18" fmla="*/ 393486 w 594654"/>
                    <a:gd name="connsiteY18" fmla="*/ 9144 h 521208"/>
                    <a:gd name="connsiteX19" fmla="*/ 366054 w 594654"/>
                    <a:gd name="connsiteY19" fmla="*/ 0 h 521208"/>
                    <a:gd name="connsiteX20" fmla="*/ 247182 w 594654"/>
                    <a:gd name="connsiteY20" fmla="*/ 9144 h 521208"/>
                    <a:gd name="connsiteX21" fmla="*/ 183174 w 594654"/>
                    <a:gd name="connsiteY21" fmla="*/ 36576 h 521208"/>
                    <a:gd name="connsiteX22" fmla="*/ 100878 w 594654"/>
                    <a:gd name="connsiteY22" fmla="*/ 100584 h 521208"/>
                    <a:gd name="connsiteX23" fmla="*/ 55158 w 594654"/>
                    <a:gd name="connsiteY23" fmla="*/ 146304 h 521208"/>
                    <a:gd name="connsiteX24" fmla="*/ 46014 w 594654"/>
                    <a:gd name="connsiteY24" fmla="*/ 182880 h 521208"/>
                    <a:gd name="connsiteX25" fmla="*/ 73446 w 594654"/>
                    <a:gd name="connsiteY25" fmla="*/ 274320 h 521208"/>
                    <a:gd name="connsiteX26" fmla="*/ 100878 w 594654"/>
                    <a:gd name="connsiteY26" fmla="*/ 292608 h 521208"/>
                    <a:gd name="connsiteX27" fmla="*/ 128310 w 594654"/>
                    <a:gd name="connsiteY27" fmla="*/ 301752 h 521208"/>
                    <a:gd name="connsiteX28" fmla="*/ 210606 w 594654"/>
                    <a:gd name="connsiteY28" fmla="*/ 292608 h 521208"/>
                    <a:gd name="connsiteX29" fmla="*/ 265470 w 594654"/>
                    <a:gd name="connsiteY29" fmla="*/ 274320 h 521208"/>
                    <a:gd name="connsiteX30" fmla="*/ 292902 w 594654"/>
                    <a:gd name="connsiteY30" fmla="*/ 246888 h 521208"/>
                    <a:gd name="connsiteX31" fmla="*/ 320334 w 594654"/>
                    <a:gd name="connsiteY31" fmla="*/ 228600 h 521208"/>
                    <a:gd name="connsiteX32" fmla="*/ 302046 w 594654"/>
                    <a:gd name="connsiteY32" fmla="*/ 265176 h 521208"/>
                    <a:gd name="connsiteX33" fmla="*/ 247182 w 594654"/>
                    <a:gd name="connsiteY33" fmla="*/ 292608 h 521208"/>
                    <a:gd name="connsiteX34" fmla="*/ 210606 w 594654"/>
                    <a:gd name="connsiteY34" fmla="*/ 310896 h 521208"/>
                    <a:gd name="connsiteX35" fmla="*/ 137454 w 594654"/>
                    <a:gd name="connsiteY35" fmla="*/ 329184 h 521208"/>
                    <a:gd name="connsiteX36" fmla="*/ 82590 w 594654"/>
                    <a:gd name="connsiteY36" fmla="*/ 365760 h 521208"/>
                    <a:gd name="connsiteX37" fmla="*/ 36870 w 594654"/>
                    <a:gd name="connsiteY37" fmla="*/ 411480 h 521208"/>
                    <a:gd name="connsiteX38" fmla="*/ 9438 w 594654"/>
                    <a:gd name="connsiteY38" fmla="*/ 493776 h 521208"/>
                    <a:gd name="connsiteX39" fmla="*/ 36870 w 594654"/>
                    <a:gd name="connsiteY39" fmla="*/ 512064 h 521208"/>
                    <a:gd name="connsiteX40" fmla="*/ 46014 w 594654"/>
                    <a:gd name="connsiteY40" fmla="*/ 521208 h 52120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</a:cxnLst>
                  <a:rect l="l" t="t" r="r" b="b"/>
                  <a:pathLst>
                    <a:path w="594654" h="521208">
                      <a:moveTo>
                        <a:pt x="46014" y="521208"/>
                      </a:moveTo>
                      <a:lnTo>
                        <a:pt x="46014" y="521208"/>
                      </a:lnTo>
                      <a:cubicBezTo>
                        <a:pt x="76494" y="499872"/>
                        <a:pt x="102158" y="468965"/>
                        <a:pt x="137454" y="457200"/>
                      </a:cubicBezTo>
                      <a:lnTo>
                        <a:pt x="192318" y="438912"/>
                      </a:lnTo>
                      <a:cubicBezTo>
                        <a:pt x="201462" y="435864"/>
                        <a:pt x="211730" y="435115"/>
                        <a:pt x="219750" y="429768"/>
                      </a:cubicBezTo>
                      <a:cubicBezTo>
                        <a:pt x="228894" y="423672"/>
                        <a:pt x="237352" y="416395"/>
                        <a:pt x="247182" y="411480"/>
                      </a:cubicBezTo>
                      <a:cubicBezTo>
                        <a:pt x="255803" y="407169"/>
                        <a:pt x="266188" y="407017"/>
                        <a:pt x="274614" y="402336"/>
                      </a:cubicBezTo>
                      <a:lnTo>
                        <a:pt x="356910" y="347472"/>
                      </a:lnTo>
                      <a:lnTo>
                        <a:pt x="384342" y="329184"/>
                      </a:lnTo>
                      <a:lnTo>
                        <a:pt x="411774" y="310896"/>
                      </a:lnTo>
                      <a:cubicBezTo>
                        <a:pt x="417870" y="301752"/>
                        <a:pt x="420743" y="289289"/>
                        <a:pt x="430062" y="283464"/>
                      </a:cubicBezTo>
                      <a:cubicBezTo>
                        <a:pt x="446409" y="273247"/>
                        <a:pt x="468886" y="275869"/>
                        <a:pt x="484926" y="265176"/>
                      </a:cubicBezTo>
                      <a:lnTo>
                        <a:pt x="512358" y="246888"/>
                      </a:lnTo>
                      <a:cubicBezTo>
                        <a:pt x="577708" y="148863"/>
                        <a:pt x="475938" y="297633"/>
                        <a:pt x="558078" y="192024"/>
                      </a:cubicBezTo>
                      <a:cubicBezTo>
                        <a:pt x="571572" y="174674"/>
                        <a:pt x="594654" y="137160"/>
                        <a:pt x="594654" y="137160"/>
                      </a:cubicBezTo>
                      <a:cubicBezTo>
                        <a:pt x="591606" y="124968"/>
                        <a:pt x="593786" y="110042"/>
                        <a:pt x="585510" y="100584"/>
                      </a:cubicBezTo>
                      <a:cubicBezTo>
                        <a:pt x="525080" y="31521"/>
                        <a:pt x="542312" y="90073"/>
                        <a:pt x="475782" y="45720"/>
                      </a:cubicBezTo>
                      <a:cubicBezTo>
                        <a:pt x="466638" y="39624"/>
                        <a:pt x="458393" y="31895"/>
                        <a:pt x="448350" y="27432"/>
                      </a:cubicBezTo>
                      <a:cubicBezTo>
                        <a:pt x="430734" y="19603"/>
                        <a:pt x="411774" y="15240"/>
                        <a:pt x="393486" y="9144"/>
                      </a:cubicBezTo>
                      <a:lnTo>
                        <a:pt x="366054" y="0"/>
                      </a:lnTo>
                      <a:cubicBezTo>
                        <a:pt x="326430" y="3048"/>
                        <a:pt x="286616" y="4215"/>
                        <a:pt x="247182" y="9144"/>
                      </a:cubicBezTo>
                      <a:cubicBezTo>
                        <a:pt x="231250" y="11136"/>
                        <a:pt x="193820" y="30189"/>
                        <a:pt x="183174" y="36576"/>
                      </a:cubicBezTo>
                      <a:cubicBezTo>
                        <a:pt x="149189" y="56967"/>
                        <a:pt x="125237" y="71353"/>
                        <a:pt x="100878" y="100584"/>
                      </a:cubicBezTo>
                      <a:cubicBezTo>
                        <a:pt x="62778" y="146304"/>
                        <a:pt x="105450" y="112776"/>
                        <a:pt x="55158" y="146304"/>
                      </a:cubicBezTo>
                      <a:cubicBezTo>
                        <a:pt x="52110" y="158496"/>
                        <a:pt x="46014" y="170313"/>
                        <a:pt x="46014" y="182880"/>
                      </a:cubicBezTo>
                      <a:cubicBezTo>
                        <a:pt x="46014" y="217413"/>
                        <a:pt x="48658" y="249532"/>
                        <a:pt x="73446" y="274320"/>
                      </a:cubicBezTo>
                      <a:cubicBezTo>
                        <a:pt x="81217" y="282091"/>
                        <a:pt x="91048" y="287693"/>
                        <a:pt x="100878" y="292608"/>
                      </a:cubicBezTo>
                      <a:cubicBezTo>
                        <a:pt x="109499" y="296919"/>
                        <a:pt x="119166" y="298704"/>
                        <a:pt x="128310" y="301752"/>
                      </a:cubicBezTo>
                      <a:cubicBezTo>
                        <a:pt x="155742" y="298704"/>
                        <a:pt x="183541" y="298021"/>
                        <a:pt x="210606" y="292608"/>
                      </a:cubicBezTo>
                      <a:cubicBezTo>
                        <a:pt x="229509" y="288827"/>
                        <a:pt x="265470" y="274320"/>
                        <a:pt x="265470" y="274320"/>
                      </a:cubicBezTo>
                      <a:cubicBezTo>
                        <a:pt x="274614" y="265176"/>
                        <a:pt x="282968" y="255167"/>
                        <a:pt x="292902" y="246888"/>
                      </a:cubicBezTo>
                      <a:cubicBezTo>
                        <a:pt x="301345" y="239853"/>
                        <a:pt x="315419" y="218770"/>
                        <a:pt x="320334" y="228600"/>
                      </a:cubicBezTo>
                      <a:cubicBezTo>
                        <a:pt x="326430" y="240792"/>
                        <a:pt x="310772" y="254704"/>
                        <a:pt x="302046" y="265176"/>
                      </a:cubicBezTo>
                      <a:cubicBezTo>
                        <a:pt x="285775" y="284701"/>
                        <a:pt x="268217" y="283593"/>
                        <a:pt x="247182" y="292608"/>
                      </a:cubicBezTo>
                      <a:cubicBezTo>
                        <a:pt x="234653" y="297978"/>
                        <a:pt x="223538" y="306585"/>
                        <a:pt x="210606" y="310896"/>
                      </a:cubicBezTo>
                      <a:cubicBezTo>
                        <a:pt x="186761" y="318844"/>
                        <a:pt x="137454" y="329184"/>
                        <a:pt x="137454" y="329184"/>
                      </a:cubicBezTo>
                      <a:cubicBezTo>
                        <a:pt x="119166" y="341376"/>
                        <a:pt x="94782" y="347472"/>
                        <a:pt x="82590" y="365760"/>
                      </a:cubicBezTo>
                      <a:cubicBezTo>
                        <a:pt x="58206" y="402336"/>
                        <a:pt x="73446" y="387096"/>
                        <a:pt x="36870" y="411480"/>
                      </a:cubicBezTo>
                      <a:cubicBezTo>
                        <a:pt x="18303" y="439331"/>
                        <a:pt x="-16898" y="460855"/>
                        <a:pt x="9438" y="493776"/>
                      </a:cubicBezTo>
                      <a:cubicBezTo>
                        <a:pt x="16303" y="502358"/>
                        <a:pt x="27040" y="507149"/>
                        <a:pt x="36870" y="512064"/>
                      </a:cubicBezTo>
                      <a:cubicBezTo>
                        <a:pt x="57086" y="522172"/>
                        <a:pt x="44490" y="519684"/>
                        <a:pt x="46014" y="521208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8" name="Freeform 17">
                  <a:extLst>
                    <a:ext uri="{FF2B5EF4-FFF2-40B4-BE49-F238E27FC236}">
                      <a16:creationId xmlns:a16="http://schemas.microsoft.com/office/drawing/2014/main" id="{C423A7B1-31BD-EB4E-45C1-494186E70F78}"/>
                    </a:ext>
                  </a:extLst>
                </p:cNvPr>
                <p:cNvSpPr/>
                <p:nvPr/>
              </p:nvSpPr>
              <p:spPr>
                <a:xfrm>
                  <a:off x="11108371" y="3681359"/>
                  <a:ext cx="393577" cy="280132"/>
                </a:xfrm>
                <a:custGeom>
                  <a:avLst/>
                  <a:gdLst>
                    <a:gd name="connsiteX0" fmla="*/ 539575 w 539575"/>
                    <a:gd name="connsiteY0" fmla="*/ 320040 h 384048"/>
                    <a:gd name="connsiteX1" fmla="*/ 539575 w 539575"/>
                    <a:gd name="connsiteY1" fmla="*/ 320040 h 384048"/>
                    <a:gd name="connsiteX2" fmla="*/ 457279 w 539575"/>
                    <a:gd name="connsiteY2" fmla="*/ 329184 h 384048"/>
                    <a:gd name="connsiteX3" fmla="*/ 347551 w 539575"/>
                    <a:gd name="connsiteY3" fmla="*/ 338328 h 384048"/>
                    <a:gd name="connsiteX4" fmla="*/ 292687 w 539575"/>
                    <a:gd name="connsiteY4" fmla="*/ 365760 h 384048"/>
                    <a:gd name="connsiteX5" fmla="*/ 237823 w 539575"/>
                    <a:gd name="connsiteY5" fmla="*/ 384048 h 384048"/>
                    <a:gd name="connsiteX6" fmla="*/ 155527 w 539575"/>
                    <a:gd name="connsiteY6" fmla="*/ 365760 h 384048"/>
                    <a:gd name="connsiteX7" fmla="*/ 109807 w 539575"/>
                    <a:gd name="connsiteY7" fmla="*/ 320040 h 384048"/>
                    <a:gd name="connsiteX8" fmla="*/ 54943 w 539575"/>
                    <a:gd name="connsiteY8" fmla="*/ 283464 h 384048"/>
                    <a:gd name="connsiteX9" fmla="*/ 9223 w 539575"/>
                    <a:gd name="connsiteY9" fmla="*/ 228600 h 384048"/>
                    <a:gd name="connsiteX10" fmla="*/ 9223 w 539575"/>
                    <a:gd name="connsiteY10" fmla="*/ 36576 h 384048"/>
                    <a:gd name="connsiteX11" fmla="*/ 27511 w 539575"/>
                    <a:gd name="connsiteY11" fmla="*/ 9144 h 384048"/>
                    <a:gd name="connsiteX12" fmla="*/ 64087 w 539575"/>
                    <a:gd name="connsiteY12" fmla="*/ 0 h 384048"/>
                    <a:gd name="connsiteX13" fmla="*/ 173815 w 539575"/>
                    <a:gd name="connsiteY13" fmla="*/ 18288 h 384048"/>
                    <a:gd name="connsiteX14" fmla="*/ 201247 w 539575"/>
                    <a:gd name="connsiteY14" fmla="*/ 27432 h 384048"/>
                    <a:gd name="connsiteX15" fmla="*/ 228679 w 539575"/>
                    <a:gd name="connsiteY15" fmla="*/ 45720 h 384048"/>
                    <a:gd name="connsiteX16" fmla="*/ 292687 w 539575"/>
                    <a:gd name="connsiteY16" fmla="*/ 109728 h 384048"/>
                    <a:gd name="connsiteX17" fmla="*/ 365839 w 539575"/>
                    <a:gd name="connsiteY17" fmla="*/ 173736 h 384048"/>
                    <a:gd name="connsiteX18" fmla="*/ 420703 w 539575"/>
                    <a:gd name="connsiteY18" fmla="*/ 201168 h 384048"/>
                    <a:gd name="connsiteX19" fmla="*/ 448135 w 539575"/>
                    <a:gd name="connsiteY19" fmla="*/ 228600 h 384048"/>
                    <a:gd name="connsiteX20" fmla="*/ 484711 w 539575"/>
                    <a:gd name="connsiteY20" fmla="*/ 283464 h 384048"/>
                    <a:gd name="connsiteX21" fmla="*/ 512143 w 539575"/>
                    <a:gd name="connsiteY21" fmla="*/ 301752 h 384048"/>
                    <a:gd name="connsiteX22" fmla="*/ 539575 w 539575"/>
                    <a:gd name="connsiteY22" fmla="*/ 320040 h 38404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</a:cxnLst>
                  <a:rect l="l" t="t" r="r" b="b"/>
                  <a:pathLst>
                    <a:path w="539575" h="384048">
                      <a:moveTo>
                        <a:pt x="539575" y="320040"/>
                      </a:moveTo>
                      <a:lnTo>
                        <a:pt x="539575" y="320040"/>
                      </a:lnTo>
                      <a:lnTo>
                        <a:pt x="457279" y="329184"/>
                      </a:lnTo>
                      <a:cubicBezTo>
                        <a:pt x="420742" y="332664"/>
                        <a:pt x="383932" y="333477"/>
                        <a:pt x="347551" y="338328"/>
                      </a:cubicBezTo>
                      <a:cubicBezTo>
                        <a:pt x="311821" y="343092"/>
                        <a:pt x="325713" y="351082"/>
                        <a:pt x="292687" y="365760"/>
                      </a:cubicBezTo>
                      <a:cubicBezTo>
                        <a:pt x="275071" y="373589"/>
                        <a:pt x="237823" y="384048"/>
                        <a:pt x="237823" y="384048"/>
                      </a:cubicBezTo>
                      <a:cubicBezTo>
                        <a:pt x="210391" y="377952"/>
                        <a:pt x="182186" y="374646"/>
                        <a:pt x="155527" y="365760"/>
                      </a:cubicBezTo>
                      <a:cubicBezTo>
                        <a:pt x="113324" y="351692"/>
                        <a:pt x="139818" y="346300"/>
                        <a:pt x="109807" y="320040"/>
                      </a:cubicBezTo>
                      <a:cubicBezTo>
                        <a:pt x="93266" y="305566"/>
                        <a:pt x="70485" y="299006"/>
                        <a:pt x="54943" y="283464"/>
                      </a:cubicBezTo>
                      <a:cubicBezTo>
                        <a:pt x="19740" y="248261"/>
                        <a:pt x="34684" y="266792"/>
                        <a:pt x="9223" y="228600"/>
                      </a:cubicBezTo>
                      <a:cubicBezTo>
                        <a:pt x="4923" y="168405"/>
                        <a:pt x="-9185" y="97937"/>
                        <a:pt x="9223" y="36576"/>
                      </a:cubicBezTo>
                      <a:cubicBezTo>
                        <a:pt x="12381" y="26050"/>
                        <a:pt x="18367" y="15240"/>
                        <a:pt x="27511" y="9144"/>
                      </a:cubicBezTo>
                      <a:cubicBezTo>
                        <a:pt x="37968" y="2173"/>
                        <a:pt x="51895" y="3048"/>
                        <a:pt x="64087" y="0"/>
                      </a:cubicBezTo>
                      <a:cubicBezTo>
                        <a:pt x="100216" y="5161"/>
                        <a:pt x="138159" y="9374"/>
                        <a:pt x="173815" y="18288"/>
                      </a:cubicBezTo>
                      <a:cubicBezTo>
                        <a:pt x="183166" y="20626"/>
                        <a:pt x="192626" y="23121"/>
                        <a:pt x="201247" y="27432"/>
                      </a:cubicBezTo>
                      <a:cubicBezTo>
                        <a:pt x="211077" y="32347"/>
                        <a:pt x="219535" y="39624"/>
                        <a:pt x="228679" y="45720"/>
                      </a:cubicBezTo>
                      <a:cubicBezTo>
                        <a:pt x="270602" y="108604"/>
                        <a:pt x="244403" y="93633"/>
                        <a:pt x="292687" y="109728"/>
                      </a:cubicBezTo>
                      <a:cubicBezTo>
                        <a:pt x="314023" y="141732"/>
                        <a:pt x="320119" y="158496"/>
                        <a:pt x="365839" y="173736"/>
                      </a:cubicBezTo>
                      <a:cubicBezTo>
                        <a:pt x="393332" y="182900"/>
                        <a:pt x="397068" y="181473"/>
                        <a:pt x="420703" y="201168"/>
                      </a:cubicBezTo>
                      <a:cubicBezTo>
                        <a:pt x="430637" y="209447"/>
                        <a:pt x="440196" y="218392"/>
                        <a:pt x="448135" y="228600"/>
                      </a:cubicBezTo>
                      <a:cubicBezTo>
                        <a:pt x="461629" y="245950"/>
                        <a:pt x="466423" y="271272"/>
                        <a:pt x="484711" y="283464"/>
                      </a:cubicBezTo>
                      <a:lnTo>
                        <a:pt x="512143" y="301752"/>
                      </a:lnTo>
                      <a:cubicBezTo>
                        <a:pt x="532122" y="331720"/>
                        <a:pt x="519441" y="329184"/>
                        <a:pt x="539575" y="320040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" name="Freeform 20">
                  <a:extLst>
                    <a:ext uri="{FF2B5EF4-FFF2-40B4-BE49-F238E27FC236}">
                      <a16:creationId xmlns:a16="http://schemas.microsoft.com/office/drawing/2014/main" id="{EA4CDBC3-8303-8C2A-27DE-D7DCC712A865}"/>
                    </a:ext>
                  </a:extLst>
                </p:cNvPr>
                <p:cNvSpPr/>
                <p:nvPr/>
              </p:nvSpPr>
              <p:spPr>
                <a:xfrm>
                  <a:off x="11408571" y="3701360"/>
                  <a:ext cx="554166" cy="233444"/>
                </a:xfrm>
                <a:custGeom>
                  <a:avLst/>
                  <a:gdLst>
                    <a:gd name="connsiteX0" fmla="*/ 0 w 759735"/>
                    <a:gd name="connsiteY0" fmla="*/ 36576 h 320040"/>
                    <a:gd name="connsiteX1" fmla="*/ 0 w 759735"/>
                    <a:gd name="connsiteY1" fmla="*/ 36576 h 320040"/>
                    <a:gd name="connsiteX2" fmla="*/ 82296 w 759735"/>
                    <a:gd name="connsiteY2" fmla="*/ 27432 h 320040"/>
                    <a:gd name="connsiteX3" fmla="*/ 109728 w 759735"/>
                    <a:gd name="connsiteY3" fmla="*/ 18288 h 320040"/>
                    <a:gd name="connsiteX4" fmla="*/ 182880 w 759735"/>
                    <a:gd name="connsiteY4" fmla="*/ 0 h 320040"/>
                    <a:gd name="connsiteX5" fmla="*/ 329184 w 759735"/>
                    <a:gd name="connsiteY5" fmla="*/ 9144 h 320040"/>
                    <a:gd name="connsiteX6" fmla="*/ 356616 w 759735"/>
                    <a:gd name="connsiteY6" fmla="*/ 18288 h 320040"/>
                    <a:gd name="connsiteX7" fmla="*/ 393192 w 759735"/>
                    <a:gd name="connsiteY7" fmla="*/ 27432 h 320040"/>
                    <a:gd name="connsiteX8" fmla="*/ 448056 w 759735"/>
                    <a:gd name="connsiteY8" fmla="*/ 64008 h 320040"/>
                    <a:gd name="connsiteX9" fmla="*/ 466344 w 759735"/>
                    <a:gd name="connsiteY9" fmla="*/ 91440 h 320040"/>
                    <a:gd name="connsiteX10" fmla="*/ 521208 w 759735"/>
                    <a:gd name="connsiteY10" fmla="*/ 109728 h 320040"/>
                    <a:gd name="connsiteX11" fmla="*/ 548640 w 759735"/>
                    <a:gd name="connsiteY11" fmla="*/ 118872 h 320040"/>
                    <a:gd name="connsiteX12" fmla="*/ 576072 w 759735"/>
                    <a:gd name="connsiteY12" fmla="*/ 128016 h 320040"/>
                    <a:gd name="connsiteX13" fmla="*/ 612648 w 759735"/>
                    <a:gd name="connsiteY13" fmla="*/ 137160 h 320040"/>
                    <a:gd name="connsiteX14" fmla="*/ 694944 w 759735"/>
                    <a:gd name="connsiteY14" fmla="*/ 164592 h 320040"/>
                    <a:gd name="connsiteX15" fmla="*/ 722376 w 759735"/>
                    <a:gd name="connsiteY15" fmla="*/ 173736 h 320040"/>
                    <a:gd name="connsiteX16" fmla="*/ 749808 w 759735"/>
                    <a:gd name="connsiteY16" fmla="*/ 182880 h 320040"/>
                    <a:gd name="connsiteX17" fmla="*/ 758952 w 759735"/>
                    <a:gd name="connsiteY17" fmla="*/ 210312 h 320040"/>
                    <a:gd name="connsiteX18" fmla="*/ 704088 w 759735"/>
                    <a:gd name="connsiteY18" fmla="*/ 237744 h 320040"/>
                    <a:gd name="connsiteX19" fmla="*/ 640080 w 759735"/>
                    <a:gd name="connsiteY19" fmla="*/ 246888 h 320040"/>
                    <a:gd name="connsiteX20" fmla="*/ 603504 w 759735"/>
                    <a:gd name="connsiteY20" fmla="*/ 256032 h 320040"/>
                    <a:gd name="connsiteX21" fmla="*/ 548640 w 759735"/>
                    <a:gd name="connsiteY21" fmla="*/ 274320 h 320040"/>
                    <a:gd name="connsiteX22" fmla="*/ 521208 w 759735"/>
                    <a:gd name="connsiteY22" fmla="*/ 283464 h 320040"/>
                    <a:gd name="connsiteX23" fmla="*/ 438912 w 759735"/>
                    <a:gd name="connsiteY23" fmla="*/ 310896 h 320040"/>
                    <a:gd name="connsiteX24" fmla="*/ 411480 w 759735"/>
                    <a:gd name="connsiteY24" fmla="*/ 320040 h 320040"/>
                    <a:gd name="connsiteX25" fmla="*/ 329184 w 759735"/>
                    <a:gd name="connsiteY25" fmla="*/ 310896 h 320040"/>
                    <a:gd name="connsiteX26" fmla="*/ 219456 w 759735"/>
                    <a:gd name="connsiteY26" fmla="*/ 256032 h 320040"/>
                    <a:gd name="connsiteX27" fmla="*/ 164592 w 759735"/>
                    <a:gd name="connsiteY27" fmla="*/ 219456 h 320040"/>
                    <a:gd name="connsiteX28" fmla="*/ 109728 w 759735"/>
                    <a:gd name="connsiteY28" fmla="*/ 182880 h 320040"/>
                    <a:gd name="connsiteX29" fmla="*/ 82296 w 759735"/>
                    <a:gd name="connsiteY29" fmla="*/ 164592 h 320040"/>
                    <a:gd name="connsiteX30" fmla="*/ 54864 w 759735"/>
                    <a:gd name="connsiteY30" fmla="*/ 137160 h 320040"/>
                    <a:gd name="connsiteX31" fmla="*/ 0 w 759735"/>
                    <a:gd name="connsiteY31" fmla="*/ 36576 h 32004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</a:cxnLst>
                  <a:rect l="l" t="t" r="r" b="b"/>
                  <a:pathLst>
                    <a:path w="759735" h="320040">
                      <a:moveTo>
                        <a:pt x="0" y="36576"/>
                      </a:moveTo>
                      <a:lnTo>
                        <a:pt x="0" y="36576"/>
                      </a:lnTo>
                      <a:cubicBezTo>
                        <a:pt x="27432" y="33528"/>
                        <a:pt x="55071" y="31970"/>
                        <a:pt x="82296" y="27432"/>
                      </a:cubicBezTo>
                      <a:cubicBezTo>
                        <a:pt x="91803" y="25847"/>
                        <a:pt x="100377" y="20626"/>
                        <a:pt x="109728" y="18288"/>
                      </a:cubicBezTo>
                      <a:lnTo>
                        <a:pt x="182880" y="0"/>
                      </a:lnTo>
                      <a:cubicBezTo>
                        <a:pt x="231648" y="3048"/>
                        <a:pt x="280589" y="4029"/>
                        <a:pt x="329184" y="9144"/>
                      </a:cubicBezTo>
                      <a:cubicBezTo>
                        <a:pt x="338770" y="10153"/>
                        <a:pt x="347348" y="15640"/>
                        <a:pt x="356616" y="18288"/>
                      </a:cubicBezTo>
                      <a:cubicBezTo>
                        <a:pt x="368700" y="21740"/>
                        <a:pt x="381000" y="24384"/>
                        <a:pt x="393192" y="27432"/>
                      </a:cubicBezTo>
                      <a:cubicBezTo>
                        <a:pt x="411480" y="39624"/>
                        <a:pt x="435864" y="45720"/>
                        <a:pt x="448056" y="64008"/>
                      </a:cubicBezTo>
                      <a:cubicBezTo>
                        <a:pt x="454152" y="73152"/>
                        <a:pt x="457025" y="85615"/>
                        <a:pt x="466344" y="91440"/>
                      </a:cubicBezTo>
                      <a:cubicBezTo>
                        <a:pt x="482691" y="101657"/>
                        <a:pt x="502920" y="103632"/>
                        <a:pt x="521208" y="109728"/>
                      </a:cubicBezTo>
                      <a:lnTo>
                        <a:pt x="548640" y="118872"/>
                      </a:lnTo>
                      <a:cubicBezTo>
                        <a:pt x="557784" y="121920"/>
                        <a:pt x="566721" y="125678"/>
                        <a:pt x="576072" y="128016"/>
                      </a:cubicBezTo>
                      <a:cubicBezTo>
                        <a:pt x="588264" y="131064"/>
                        <a:pt x="600611" y="133549"/>
                        <a:pt x="612648" y="137160"/>
                      </a:cubicBezTo>
                      <a:lnTo>
                        <a:pt x="694944" y="164592"/>
                      </a:lnTo>
                      <a:lnTo>
                        <a:pt x="722376" y="173736"/>
                      </a:lnTo>
                      <a:lnTo>
                        <a:pt x="749808" y="182880"/>
                      </a:lnTo>
                      <a:cubicBezTo>
                        <a:pt x="752856" y="192024"/>
                        <a:pt x="762532" y="201363"/>
                        <a:pt x="758952" y="210312"/>
                      </a:cubicBezTo>
                      <a:cubicBezTo>
                        <a:pt x="754261" y="222039"/>
                        <a:pt x="714967" y="235568"/>
                        <a:pt x="704088" y="237744"/>
                      </a:cubicBezTo>
                      <a:cubicBezTo>
                        <a:pt x="682954" y="241971"/>
                        <a:pt x="661285" y="243033"/>
                        <a:pt x="640080" y="246888"/>
                      </a:cubicBezTo>
                      <a:cubicBezTo>
                        <a:pt x="627715" y="249136"/>
                        <a:pt x="615541" y="252421"/>
                        <a:pt x="603504" y="256032"/>
                      </a:cubicBezTo>
                      <a:cubicBezTo>
                        <a:pt x="585040" y="261571"/>
                        <a:pt x="566928" y="268224"/>
                        <a:pt x="548640" y="274320"/>
                      </a:cubicBezTo>
                      <a:lnTo>
                        <a:pt x="521208" y="283464"/>
                      </a:lnTo>
                      <a:lnTo>
                        <a:pt x="438912" y="310896"/>
                      </a:lnTo>
                      <a:lnTo>
                        <a:pt x="411480" y="320040"/>
                      </a:lnTo>
                      <a:cubicBezTo>
                        <a:pt x="384048" y="316992"/>
                        <a:pt x="356249" y="316309"/>
                        <a:pt x="329184" y="310896"/>
                      </a:cubicBezTo>
                      <a:cubicBezTo>
                        <a:pt x="275101" y="300079"/>
                        <a:pt x="265694" y="286857"/>
                        <a:pt x="219456" y="256032"/>
                      </a:cubicBezTo>
                      <a:lnTo>
                        <a:pt x="164592" y="219456"/>
                      </a:lnTo>
                      <a:lnTo>
                        <a:pt x="109728" y="182880"/>
                      </a:lnTo>
                      <a:cubicBezTo>
                        <a:pt x="100584" y="176784"/>
                        <a:pt x="90067" y="172363"/>
                        <a:pt x="82296" y="164592"/>
                      </a:cubicBezTo>
                      <a:cubicBezTo>
                        <a:pt x="73152" y="155448"/>
                        <a:pt x="62803" y="147368"/>
                        <a:pt x="54864" y="137160"/>
                      </a:cubicBezTo>
                      <a:cubicBezTo>
                        <a:pt x="-17513" y="44104"/>
                        <a:pt x="9144" y="53340"/>
                        <a:pt x="0" y="36576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8" name="Freeform 27">
                  <a:extLst>
                    <a:ext uri="{FF2B5EF4-FFF2-40B4-BE49-F238E27FC236}">
                      <a16:creationId xmlns:a16="http://schemas.microsoft.com/office/drawing/2014/main" id="{92442A7C-0D6F-ABA1-E6E4-C35E3EE3D42A}"/>
                    </a:ext>
                  </a:extLst>
                </p:cNvPr>
                <p:cNvSpPr/>
                <p:nvPr/>
              </p:nvSpPr>
              <p:spPr>
                <a:xfrm>
                  <a:off x="10595537" y="5070437"/>
                  <a:ext cx="590022" cy="205684"/>
                </a:xfrm>
                <a:custGeom>
                  <a:avLst/>
                  <a:gdLst>
                    <a:gd name="connsiteX0" fmla="*/ 0 w 808892"/>
                    <a:gd name="connsiteY0" fmla="*/ 141306 h 281983"/>
                    <a:gd name="connsiteX1" fmla="*/ 0 w 808892"/>
                    <a:gd name="connsiteY1" fmla="*/ 141306 h 281983"/>
                    <a:gd name="connsiteX2" fmla="*/ 82061 w 808892"/>
                    <a:gd name="connsiteY2" fmla="*/ 82691 h 281983"/>
                    <a:gd name="connsiteX3" fmla="*/ 105508 w 808892"/>
                    <a:gd name="connsiteY3" fmla="*/ 59244 h 281983"/>
                    <a:gd name="connsiteX4" fmla="*/ 140677 w 808892"/>
                    <a:gd name="connsiteY4" fmla="*/ 47521 h 281983"/>
                    <a:gd name="connsiteX5" fmla="*/ 164123 w 808892"/>
                    <a:gd name="connsiteY5" fmla="*/ 12352 h 281983"/>
                    <a:gd name="connsiteX6" fmla="*/ 304800 w 808892"/>
                    <a:gd name="connsiteY6" fmla="*/ 12352 h 281983"/>
                    <a:gd name="connsiteX7" fmla="*/ 351692 w 808892"/>
                    <a:gd name="connsiteY7" fmla="*/ 82691 h 281983"/>
                    <a:gd name="connsiteX8" fmla="*/ 410308 w 808892"/>
                    <a:gd name="connsiteY8" fmla="*/ 141306 h 281983"/>
                    <a:gd name="connsiteX9" fmla="*/ 480646 w 808892"/>
                    <a:gd name="connsiteY9" fmla="*/ 164752 h 281983"/>
                    <a:gd name="connsiteX10" fmla="*/ 773723 w 808892"/>
                    <a:gd name="connsiteY10" fmla="*/ 164752 h 281983"/>
                    <a:gd name="connsiteX11" fmla="*/ 808892 w 808892"/>
                    <a:gd name="connsiteY11" fmla="*/ 188198 h 281983"/>
                    <a:gd name="connsiteX12" fmla="*/ 797169 w 808892"/>
                    <a:gd name="connsiteY12" fmla="*/ 235091 h 281983"/>
                    <a:gd name="connsiteX13" fmla="*/ 762000 w 808892"/>
                    <a:gd name="connsiteY13" fmla="*/ 258537 h 281983"/>
                    <a:gd name="connsiteX14" fmla="*/ 562708 w 808892"/>
                    <a:gd name="connsiteY14" fmla="*/ 281983 h 281983"/>
                    <a:gd name="connsiteX15" fmla="*/ 269631 w 808892"/>
                    <a:gd name="connsiteY15" fmla="*/ 270260 h 281983"/>
                    <a:gd name="connsiteX16" fmla="*/ 140677 w 808892"/>
                    <a:gd name="connsiteY16" fmla="*/ 235091 h 281983"/>
                    <a:gd name="connsiteX17" fmla="*/ 93784 w 808892"/>
                    <a:gd name="connsiteY17" fmla="*/ 188198 h 281983"/>
                    <a:gd name="connsiteX18" fmla="*/ 0 w 808892"/>
                    <a:gd name="connsiteY18" fmla="*/ 141306 h 281983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</a:cxnLst>
                  <a:rect l="l" t="t" r="r" b="b"/>
                  <a:pathLst>
                    <a:path w="808892" h="281983">
                      <a:moveTo>
                        <a:pt x="0" y="141306"/>
                      </a:moveTo>
                      <a:lnTo>
                        <a:pt x="0" y="141306"/>
                      </a:lnTo>
                      <a:cubicBezTo>
                        <a:pt x="27354" y="121768"/>
                        <a:pt x="55527" y="103329"/>
                        <a:pt x="82061" y="82691"/>
                      </a:cubicBezTo>
                      <a:cubicBezTo>
                        <a:pt x="90786" y="75905"/>
                        <a:pt x="96030" y="64931"/>
                        <a:pt x="105508" y="59244"/>
                      </a:cubicBezTo>
                      <a:cubicBezTo>
                        <a:pt x="116104" y="52886"/>
                        <a:pt x="128954" y="51429"/>
                        <a:pt x="140677" y="47521"/>
                      </a:cubicBezTo>
                      <a:cubicBezTo>
                        <a:pt x="148492" y="35798"/>
                        <a:pt x="153121" y="21154"/>
                        <a:pt x="164123" y="12352"/>
                      </a:cubicBezTo>
                      <a:cubicBezTo>
                        <a:pt x="197654" y="-14473"/>
                        <a:pt x="287831" y="10467"/>
                        <a:pt x="304800" y="12352"/>
                      </a:cubicBezTo>
                      <a:lnTo>
                        <a:pt x="351692" y="82691"/>
                      </a:lnTo>
                      <a:cubicBezTo>
                        <a:pt x="373082" y="114776"/>
                        <a:pt x="373287" y="124852"/>
                        <a:pt x="410308" y="141306"/>
                      </a:cubicBezTo>
                      <a:cubicBezTo>
                        <a:pt x="432892" y="151343"/>
                        <a:pt x="480646" y="164752"/>
                        <a:pt x="480646" y="164752"/>
                      </a:cubicBezTo>
                      <a:cubicBezTo>
                        <a:pt x="580135" y="158119"/>
                        <a:pt x="675279" y="142034"/>
                        <a:pt x="773723" y="164752"/>
                      </a:cubicBezTo>
                      <a:cubicBezTo>
                        <a:pt x="787451" y="167920"/>
                        <a:pt x="797169" y="180383"/>
                        <a:pt x="808892" y="188198"/>
                      </a:cubicBezTo>
                      <a:cubicBezTo>
                        <a:pt x="804984" y="203829"/>
                        <a:pt x="806106" y="221685"/>
                        <a:pt x="797169" y="235091"/>
                      </a:cubicBezTo>
                      <a:cubicBezTo>
                        <a:pt x="789354" y="246814"/>
                        <a:pt x="774602" y="252236"/>
                        <a:pt x="762000" y="258537"/>
                      </a:cubicBezTo>
                      <a:cubicBezTo>
                        <a:pt x="708710" y="285182"/>
                        <a:pt x="588640" y="280131"/>
                        <a:pt x="562708" y="281983"/>
                      </a:cubicBezTo>
                      <a:cubicBezTo>
                        <a:pt x="465016" y="278075"/>
                        <a:pt x="367000" y="279112"/>
                        <a:pt x="269631" y="270260"/>
                      </a:cubicBezTo>
                      <a:cubicBezTo>
                        <a:pt x="233270" y="266955"/>
                        <a:pt x="179798" y="248131"/>
                        <a:pt x="140677" y="235091"/>
                      </a:cubicBezTo>
                      <a:cubicBezTo>
                        <a:pt x="125046" y="219460"/>
                        <a:pt x="114755" y="195188"/>
                        <a:pt x="93784" y="188198"/>
                      </a:cubicBezTo>
                      <a:cubicBezTo>
                        <a:pt x="48130" y="172980"/>
                        <a:pt x="15631" y="149121"/>
                        <a:pt x="0" y="141306"/>
                      </a:cubicBezTo>
                      <a:close/>
                    </a:path>
                  </a:pathLst>
                </a:custGeom>
                <a:solidFill>
                  <a:srgbClr val="7030A0">
                    <a:alpha val="36078"/>
                  </a:srgb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" name="Rectangle 28">
                  <a:extLst>
                    <a:ext uri="{FF2B5EF4-FFF2-40B4-BE49-F238E27FC236}">
                      <a16:creationId xmlns:a16="http://schemas.microsoft.com/office/drawing/2014/main" id="{FEAA8657-C9FD-0DF0-82BA-1071B836CC71}"/>
                    </a:ext>
                  </a:extLst>
                </p:cNvPr>
                <p:cNvSpPr/>
                <p:nvPr/>
              </p:nvSpPr>
              <p:spPr>
                <a:xfrm>
                  <a:off x="7665917" y="325955"/>
                  <a:ext cx="2186413" cy="1691104"/>
                </a:xfrm>
                <a:prstGeom prst="rect">
                  <a:avLst/>
                </a:prstGeom>
                <a:noFill/>
                <a:ln w="28575"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0" name="Rectangle 29">
                  <a:extLst>
                    <a:ext uri="{FF2B5EF4-FFF2-40B4-BE49-F238E27FC236}">
                      <a16:creationId xmlns:a16="http://schemas.microsoft.com/office/drawing/2014/main" id="{EE379760-F43D-BCA8-6214-339608BBC946}"/>
                    </a:ext>
                  </a:extLst>
                </p:cNvPr>
                <p:cNvSpPr/>
                <p:nvPr/>
              </p:nvSpPr>
              <p:spPr>
                <a:xfrm>
                  <a:off x="7490539" y="3009428"/>
                  <a:ext cx="2437300" cy="1925848"/>
                </a:xfrm>
                <a:prstGeom prst="rect">
                  <a:avLst/>
                </a:prstGeom>
                <a:noFill/>
                <a:ln w="28575">
                  <a:solidFill>
                    <a:schemeClr val="bg1"/>
                  </a:solidFill>
                  <a:prstDash val="sysDash"/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A04A1C49-75C7-01EE-DC02-C3BD4BB791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9772435" y="251187"/>
                  <a:ext cx="326442" cy="88215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A2E38731-8683-11F7-AA56-AE4AA532B0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852330" y="2017059"/>
                  <a:ext cx="259174" cy="758513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Connector 34">
                  <a:extLst>
                    <a:ext uri="{FF2B5EF4-FFF2-40B4-BE49-F238E27FC236}">
                      <a16:creationId xmlns:a16="http://schemas.microsoft.com/office/drawing/2014/main" id="{7CB14085-61AC-72AD-6EEB-ACEF6D68598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9945890" y="2775572"/>
                  <a:ext cx="156799" cy="227397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id="{F8B22F3A-BBCA-50B9-C818-FC3DDAA1D7B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927839" y="4935276"/>
                  <a:ext cx="174850" cy="364681"/>
                </a:xfrm>
                <a:prstGeom prst="line">
                  <a:avLst/>
                </a:prstGeom>
                <a:ln w="285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43" name="Freeform 42">
              <a:extLst>
                <a:ext uri="{FF2B5EF4-FFF2-40B4-BE49-F238E27FC236}">
                  <a16:creationId xmlns:a16="http://schemas.microsoft.com/office/drawing/2014/main" id="{B971AAB6-1A3E-0E10-0A2F-0D7FB4B09ABC}"/>
                </a:ext>
              </a:extLst>
            </p:cNvPr>
            <p:cNvSpPr/>
            <p:nvPr/>
          </p:nvSpPr>
          <p:spPr>
            <a:xfrm>
              <a:off x="4407340" y="660771"/>
              <a:ext cx="403441" cy="320374"/>
            </a:xfrm>
            <a:custGeom>
              <a:avLst/>
              <a:gdLst>
                <a:gd name="connsiteX0" fmla="*/ 391591 w 403441"/>
                <a:gd name="connsiteY0" fmla="*/ 0 h 320374"/>
                <a:gd name="connsiteX1" fmla="*/ 391591 w 403441"/>
                <a:gd name="connsiteY1" fmla="*/ 0 h 320374"/>
                <a:gd name="connsiteX2" fmla="*/ 344870 w 403441"/>
                <a:gd name="connsiteY2" fmla="*/ 33372 h 320374"/>
                <a:gd name="connsiteX3" fmla="*/ 324847 w 403441"/>
                <a:gd name="connsiteY3" fmla="*/ 40047 h 320374"/>
                <a:gd name="connsiteX4" fmla="*/ 284800 w 403441"/>
                <a:gd name="connsiteY4" fmla="*/ 66744 h 320374"/>
                <a:gd name="connsiteX5" fmla="*/ 264777 w 403441"/>
                <a:gd name="connsiteY5" fmla="*/ 80093 h 320374"/>
                <a:gd name="connsiteX6" fmla="*/ 244753 w 403441"/>
                <a:gd name="connsiteY6" fmla="*/ 100117 h 320374"/>
                <a:gd name="connsiteX7" fmla="*/ 224730 w 403441"/>
                <a:gd name="connsiteY7" fmla="*/ 106791 h 320374"/>
                <a:gd name="connsiteX8" fmla="*/ 164660 w 403441"/>
                <a:gd name="connsiteY8" fmla="*/ 140163 h 320374"/>
                <a:gd name="connsiteX9" fmla="*/ 124613 w 403441"/>
                <a:gd name="connsiteY9" fmla="*/ 166861 h 320374"/>
                <a:gd name="connsiteX10" fmla="*/ 104590 w 403441"/>
                <a:gd name="connsiteY10" fmla="*/ 180210 h 320374"/>
                <a:gd name="connsiteX11" fmla="*/ 84567 w 403441"/>
                <a:gd name="connsiteY11" fmla="*/ 186884 h 320374"/>
                <a:gd name="connsiteX12" fmla="*/ 64543 w 403441"/>
                <a:gd name="connsiteY12" fmla="*/ 200233 h 320374"/>
                <a:gd name="connsiteX13" fmla="*/ 31171 w 403441"/>
                <a:gd name="connsiteY13" fmla="*/ 233606 h 320374"/>
                <a:gd name="connsiteX14" fmla="*/ 17822 w 403441"/>
                <a:gd name="connsiteY14" fmla="*/ 313699 h 320374"/>
                <a:gd name="connsiteX15" fmla="*/ 37845 w 403441"/>
                <a:gd name="connsiteY15" fmla="*/ 320374 h 320374"/>
                <a:gd name="connsiteX16" fmla="*/ 104590 w 403441"/>
                <a:gd name="connsiteY16" fmla="*/ 307025 h 320374"/>
                <a:gd name="connsiteX17" fmla="*/ 144637 w 403441"/>
                <a:gd name="connsiteY17" fmla="*/ 280327 h 320374"/>
                <a:gd name="connsiteX18" fmla="*/ 164660 w 403441"/>
                <a:gd name="connsiteY18" fmla="*/ 266978 h 320374"/>
                <a:gd name="connsiteX19" fmla="*/ 184683 w 403441"/>
                <a:gd name="connsiteY19" fmla="*/ 253629 h 320374"/>
                <a:gd name="connsiteX20" fmla="*/ 218056 w 403441"/>
                <a:gd name="connsiteY20" fmla="*/ 226931 h 320374"/>
                <a:gd name="connsiteX21" fmla="*/ 231405 w 403441"/>
                <a:gd name="connsiteY21" fmla="*/ 206908 h 320374"/>
                <a:gd name="connsiteX22" fmla="*/ 251428 w 403441"/>
                <a:gd name="connsiteY22" fmla="*/ 200233 h 320374"/>
                <a:gd name="connsiteX23" fmla="*/ 291475 w 403441"/>
                <a:gd name="connsiteY23" fmla="*/ 173536 h 320374"/>
                <a:gd name="connsiteX24" fmla="*/ 311498 w 403441"/>
                <a:gd name="connsiteY24" fmla="*/ 166861 h 320374"/>
                <a:gd name="connsiteX25" fmla="*/ 351545 w 403441"/>
                <a:gd name="connsiteY25" fmla="*/ 133489 h 320374"/>
                <a:gd name="connsiteX26" fmla="*/ 371568 w 403441"/>
                <a:gd name="connsiteY26" fmla="*/ 120140 h 320374"/>
                <a:gd name="connsiteX27" fmla="*/ 398266 w 403441"/>
                <a:gd name="connsiteY27" fmla="*/ 80093 h 320374"/>
                <a:gd name="connsiteX28" fmla="*/ 391591 w 403441"/>
                <a:gd name="connsiteY28" fmla="*/ 0 h 32037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403441" h="320374">
                  <a:moveTo>
                    <a:pt x="391591" y="0"/>
                  </a:moveTo>
                  <a:lnTo>
                    <a:pt x="391591" y="0"/>
                  </a:lnTo>
                  <a:cubicBezTo>
                    <a:pt x="376017" y="11124"/>
                    <a:pt x="361281" y="23525"/>
                    <a:pt x="344870" y="33372"/>
                  </a:cubicBezTo>
                  <a:cubicBezTo>
                    <a:pt x="338837" y="36992"/>
                    <a:pt x="330997" y="36630"/>
                    <a:pt x="324847" y="40047"/>
                  </a:cubicBezTo>
                  <a:cubicBezTo>
                    <a:pt x="310823" y="47838"/>
                    <a:pt x="298149" y="57845"/>
                    <a:pt x="284800" y="66744"/>
                  </a:cubicBezTo>
                  <a:cubicBezTo>
                    <a:pt x="278126" y="71194"/>
                    <a:pt x="270449" y="74421"/>
                    <a:pt x="264777" y="80093"/>
                  </a:cubicBezTo>
                  <a:cubicBezTo>
                    <a:pt x="258102" y="86768"/>
                    <a:pt x="252607" y="94881"/>
                    <a:pt x="244753" y="100117"/>
                  </a:cubicBezTo>
                  <a:cubicBezTo>
                    <a:pt x="238899" y="104019"/>
                    <a:pt x="231404" y="104566"/>
                    <a:pt x="224730" y="106791"/>
                  </a:cubicBezTo>
                  <a:cubicBezTo>
                    <a:pt x="178829" y="137391"/>
                    <a:pt x="199903" y="128416"/>
                    <a:pt x="164660" y="140163"/>
                  </a:cubicBezTo>
                  <a:lnTo>
                    <a:pt x="124613" y="166861"/>
                  </a:lnTo>
                  <a:cubicBezTo>
                    <a:pt x="117939" y="171311"/>
                    <a:pt x="112200" y="177673"/>
                    <a:pt x="104590" y="180210"/>
                  </a:cubicBezTo>
                  <a:lnTo>
                    <a:pt x="84567" y="186884"/>
                  </a:lnTo>
                  <a:cubicBezTo>
                    <a:pt x="77892" y="191334"/>
                    <a:pt x="70215" y="194561"/>
                    <a:pt x="64543" y="200233"/>
                  </a:cubicBezTo>
                  <a:cubicBezTo>
                    <a:pt x="20043" y="244733"/>
                    <a:pt x="84569" y="198007"/>
                    <a:pt x="31171" y="233606"/>
                  </a:cubicBezTo>
                  <a:cubicBezTo>
                    <a:pt x="27219" y="239534"/>
                    <a:pt x="-27396" y="298625"/>
                    <a:pt x="17822" y="313699"/>
                  </a:cubicBezTo>
                  <a:lnTo>
                    <a:pt x="37845" y="320374"/>
                  </a:lnTo>
                  <a:cubicBezTo>
                    <a:pt x="49448" y="318716"/>
                    <a:pt x="88462" y="315985"/>
                    <a:pt x="104590" y="307025"/>
                  </a:cubicBezTo>
                  <a:cubicBezTo>
                    <a:pt x="118615" y="299234"/>
                    <a:pt x="131288" y="289226"/>
                    <a:pt x="144637" y="280327"/>
                  </a:cubicBezTo>
                  <a:lnTo>
                    <a:pt x="164660" y="266978"/>
                  </a:lnTo>
                  <a:lnTo>
                    <a:pt x="184683" y="253629"/>
                  </a:lnTo>
                  <a:cubicBezTo>
                    <a:pt x="222938" y="196247"/>
                    <a:pt x="172000" y="263775"/>
                    <a:pt x="218056" y="226931"/>
                  </a:cubicBezTo>
                  <a:cubicBezTo>
                    <a:pt x="224320" y="221920"/>
                    <a:pt x="225141" y="211919"/>
                    <a:pt x="231405" y="206908"/>
                  </a:cubicBezTo>
                  <a:cubicBezTo>
                    <a:pt x="236899" y="202513"/>
                    <a:pt x="245278" y="203650"/>
                    <a:pt x="251428" y="200233"/>
                  </a:cubicBezTo>
                  <a:cubicBezTo>
                    <a:pt x="265452" y="192442"/>
                    <a:pt x="276255" y="178610"/>
                    <a:pt x="291475" y="173536"/>
                  </a:cubicBezTo>
                  <a:cubicBezTo>
                    <a:pt x="298149" y="171311"/>
                    <a:pt x="305205" y="170007"/>
                    <a:pt x="311498" y="166861"/>
                  </a:cubicBezTo>
                  <a:cubicBezTo>
                    <a:pt x="336353" y="154433"/>
                    <a:pt x="329405" y="151939"/>
                    <a:pt x="351545" y="133489"/>
                  </a:cubicBezTo>
                  <a:cubicBezTo>
                    <a:pt x="357707" y="128354"/>
                    <a:pt x="364894" y="124590"/>
                    <a:pt x="371568" y="120140"/>
                  </a:cubicBezTo>
                  <a:cubicBezTo>
                    <a:pt x="380467" y="106791"/>
                    <a:pt x="393192" y="95313"/>
                    <a:pt x="398266" y="80093"/>
                  </a:cubicBezTo>
                  <a:cubicBezTo>
                    <a:pt x="412610" y="37062"/>
                    <a:pt x="392703" y="13349"/>
                    <a:pt x="391591" y="0"/>
                  </a:cubicBezTo>
                  <a:close/>
                </a:path>
              </a:pathLst>
            </a:custGeom>
            <a:solidFill>
              <a:srgbClr val="7030A0">
                <a:alpha val="36078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Freeform 44">
              <a:extLst>
                <a:ext uri="{FF2B5EF4-FFF2-40B4-BE49-F238E27FC236}">
                  <a16:creationId xmlns:a16="http://schemas.microsoft.com/office/drawing/2014/main" id="{BBFD12B6-59AF-09F5-C867-C2501437D8B5}"/>
                </a:ext>
              </a:extLst>
            </p:cNvPr>
            <p:cNvSpPr/>
            <p:nvPr/>
          </p:nvSpPr>
          <p:spPr>
            <a:xfrm>
              <a:off x="4645419" y="2115801"/>
              <a:ext cx="387118" cy="547306"/>
            </a:xfrm>
            <a:custGeom>
              <a:avLst/>
              <a:gdLst>
                <a:gd name="connsiteX0" fmla="*/ 360420 w 387118"/>
                <a:gd name="connsiteY0" fmla="*/ 0 h 547306"/>
                <a:gd name="connsiteX1" fmla="*/ 360420 w 387118"/>
                <a:gd name="connsiteY1" fmla="*/ 0 h 547306"/>
                <a:gd name="connsiteX2" fmla="*/ 293676 w 387118"/>
                <a:gd name="connsiteY2" fmla="*/ 46722 h 547306"/>
                <a:gd name="connsiteX3" fmla="*/ 253629 w 387118"/>
                <a:gd name="connsiteY3" fmla="*/ 73419 h 547306"/>
                <a:gd name="connsiteX4" fmla="*/ 213582 w 387118"/>
                <a:gd name="connsiteY4" fmla="*/ 100117 h 547306"/>
                <a:gd name="connsiteX5" fmla="*/ 193559 w 387118"/>
                <a:gd name="connsiteY5" fmla="*/ 106792 h 547306"/>
                <a:gd name="connsiteX6" fmla="*/ 153512 w 387118"/>
                <a:gd name="connsiteY6" fmla="*/ 126815 h 547306"/>
                <a:gd name="connsiteX7" fmla="*/ 113466 w 387118"/>
                <a:gd name="connsiteY7" fmla="*/ 153513 h 547306"/>
                <a:gd name="connsiteX8" fmla="*/ 93442 w 387118"/>
                <a:gd name="connsiteY8" fmla="*/ 166862 h 547306"/>
                <a:gd name="connsiteX9" fmla="*/ 73419 w 387118"/>
                <a:gd name="connsiteY9" fmla="*/ 173536 h 547306"/>
                <a:gd name="connsiteX10" fmla="*/ 53396 w 387118"/>
                <a:gd name="connsiteY10" fmla="*/ 186885 h 547306"/>
                <a:gd name="connsiteX11" fmla="*/ 60070 w 387118"/>
                <a:gd name="connsiteY11" fmla="*/ 206908 h 547306"/>
                <a:gd name="connsiteX12" fmla="*/ 106791 w 387118"/>
                <a:gd name="connsiteY12" fmla="*/ 220257 h 547306"/>
                <a:gd name="connsiteX13" fmla="*/ 100117 w 387118"/>
                <a:gd name="connsiteY13" fmla="*/ 253630 h 547306"/>
                <a:gd name="connsiteX14" fmla="*/ 73419 w 387118"/>
                <a:gd name="connsiteY14" fmla="*/ 293676 h 547306"/>
                <a:gd name="connsiteX15" fmla="*/ 40047 w 387118"/>
                <a:gd name="connsiteY15" fmla="*/ 327049 h 547306"/>
                <a:gd name="connsiteX16" fmla="*/ 13349 w 387118"/>
                <a:gd name="connsiteY16" fmla="*/ 367095 h 547306"/>
                <a:gd name="connsiteX17" fmla="*/ 0 w 387118"/>
                <a:gd name="connsiteY17" fmla="*/ 407142 h 547306"/>
                <a:gd name="connsiteX18" fmla="*/ 6674 w 387118"/>
                <a:gd name="connsiteY18" fmla="*/ 487235 h 547306"/>
                <a:gd name="connsiteX19" fmla="*/ 13349 w 387118"/>
                <a:gd name="connsiteY19" fmla="*/ 540631 h 547306"/>
                <a:gd name="connsiteX20" fmla="*/ 33372 w 387118"/>
                <a:gd name="connsiteY20" fmla="*/ 547306 h 547306"/>
                <a:gd name="connsiteX21" fmla="*/ 66745 w 387118"/>
                <a:gd name="connsiteY21" fmla="*/ 540631 h 547306"/>
                <a:gd name="connsiteX22" fmla="*/ 73419 w 387118"/>
                <a:gd name="connsiteY22" fmla="*/ 520608 h 547306"/>
                <a:gd name="connsiteX23" fmla="*/ 106791 w 387118"/>
                <a:gd name="connsiteY23" fmla="*/ 487235 h 547306"/>
                <a:gd name="connsiteX24" fmla="*/ 120140 w 387118"/>
                <a:gd name="connsiteY24" fmla="*/ 440514 h 547306"/>
                <a:gd name="connsiteX25" fmla="*/ 126815 w 387118"/>
                <a:gd name="connsiteY25" fmla="*/ 373770 h 547306"/>
                <a:gd name="connsiteX26" fmla="*/ 140163 w 387118"/>
                <a:gd name="connsiteY26" fmla="*/ 307025 h 547306"/>
                <a:gd name="connsiteX27" fmla="*/ 153512 w 387118"/>
                <a:gd name="connsiteY27" fmla="*/ 266979 h 547306"/>
                <a:gd name="connsiteX28" fmla="*/ 180210 w 387118"/>
                <a:gd name="connsiteY28" fmla="*/ 226932 h 547306"/>
                <a:gd name="connsiteX29" fmla="*/ 200234 w 387118"/>
                <a:gd name="connsiteY29" fmla="*/ 213583 h 547306"/>
                <a:gd name="connsiteX30" fmla="*/ 213582 w 387118"/>
                <a:gd name="connsiteY30" fmla="*/ 193560 h 547306"/>
                <a:gd name="connsiteX31" fmla="*/ 233606 w 387118"/>
                <a:gd name="connsiteY31" fmla="*/ 180211 h 547306"/>
                <a:gd name="connsiteX32" fmla="*/ 260304 w 387118"/>
                <a:gd name="connsiteY32" fmla="*/ 140164 h 547306"/>
                <a:gd name="connsiteX33" fmla="*/ 300350 w 387118"/>
                <a:gd name="connsiteY33" fmla="*/ 113466 h 547306"/>
                <a:gd name="connsiteX34" fmla="*/ 320374 w 387118"/>
                <a:gd name="connsiteY34" fmla="*/ 100117 h 547306"/>
                <a:gd name="connsiteX35" fmla="*/ 353746 w 387118"/>
                <a:gd name="connsiteY35" fmla="*/ 66745 h 547306"/>
                <a:gd name="connsiteX36" fmla="*/ 387118 w 387118"/>
                <a:gd name="connsiteY36" fmla="*/ 33373 h 547306"/>
                <a:gd name="connsiteX37" fmla="*/ 360420 w 387118"/>
                <a:gd name="connsiteY37" fmla="*/ 0 h 54730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</a:cxnLst>
              <a:rect l="l" t="t" r="r" b="b"/>
              <a:pathLst>
                <a:path w="387118" h="547306">
                  <a:moveTo>
                    <a:pt x="360420" y="0"/>
                  </a:moveTo>
                  <a:lnTo>
                    <a:pt x="360420" y="0"/>
                  </a:lnTo>
                  <a:lnTo>
                    <a:pt x="293676" y="46722"/>
                  </a:lnTo>
                  <a:cubicBezTo>
                    <a:pt x="293589" y="46782"/>
                    <a:pt x="253716" y="73361"/>
                    <a:pt x="253629" y="73419"/>
                  </a:cubicBezTo>
                  <a:lnTo>
                    <a:pt x="213582" y="100117"/>
                  </a:lnTo>
                  <a:cubicBezTo>
                    <a:pt x="206908" y="102342"/>
                    <a:pt x="199852" y="103646"/>
                    <a:pt x="193559" y="106792"/>
                  </a:cubicBezTo>
                  <a:cubicBezTo>
                    <a:pt x="141815" y="132665"/>
                    <a:pt x="203833" y="110043"/>
                    <a:pt x="153512" y="126815"/>
                  </a:cubicBezTo>
                  <a:lnTo>
                    <a:pt x="113466" y="153513"/>
                  </a:lnTo>
                  <a:cubicBezTo>
                    <a:pt x="106791" y="157963"/>
                    <a:pt x="101052" y="164325"/>
                    <a:pt x="93442" y="166862"/>
                  </a:cubicBezTo>
                  <a:lnTo>
                    <a:pt x="73419" y="173536"/>
                  </a:lnTo>
                  <a:cubicBezTo>
                    <a:pt x="66745" y="177986"/>
                    <a:pt x="56375" y="179437"/>
                    <a:pt x="53396" y="186885"/>
                  </a:cubicBezTo>
                  <a:cubicBezTo>
                    <a:pt x="50783" y="193417"/>
                    <a:pt x="55095" y="201933"/>
                    <a:pt x="60070" y="206908"/>
                  </a:cubicBezTo>
                  <a:cubicBezTo>
                    <a:pt x="63263" y="210102"/>
                    <a:pt x="106557" y="220199"/>
                    <a:pt x="106791" y="220257"/>
                  </a:cubicBezTo>
                  <a:cubicBezTo>
                    <a:pt x="104566" y="231381"/>
                    <a:pt x="104811" y="243302"/>
                    <a:pt x="100117" y="253630"/>
                  </a:cubicBezTo>
                  <a:cubicBezTo>
                    <a:pt x="93478" y="268235"/>
                    <a:pt x="82318" y="280327"/>
                    <a:pt x="73419" y="293676"/>
                  </a:cubicBezTo>
                  <a:cubicBezTo>
                    <a:pt x="55619" y="320375"/>
                    <a:pt x="66746" y="309249"/>
                    <a:pt x="40047" y="327049"/>
                  </a:cubicBezTo>
                  <a:cubicBezTo>
                    <a:pt x="17962" y="393298"/>
                    <a:pt x="55017" y="292093"/>
                    <a:pt x="13349" y="367095"/>
                  </a:cubicBezTo>
                  <a:cubicBezTo>
                    <a:pt x="6516" y="379395"/>
                    <a:pt x="0" y="407142"/>
                    <a:pt x="0" y="407142"/>
                  </a:cubicBezTo>
                  <a:cubicBezTo>
                    <a:pt x="2225" y="433840"/>
                    <a:pt x="4008" y="460578"/>
                    <a:pt x="6674" y="487235"/>
                  </a:cubicBezTo>
                  <a:cubicBezTo>
                    <a:pt x="8459" y="505083"/>
                    <a:pt x="6064" y="524240"/>
                    <a:pt x="13349" y="540631"/>
                  </a:cubicBezTo>
                  <a:cubicBezTo>
                    <a:pt x="16206" y="547060"/>
                    <a:pt x="26698" y="545081"/>
                    <a:pt x="33372" y="547306"/>
                  </a:cubicBezTo>
                  <a:cubicBezTo>
                    <a:pt x="44496" y="545081"/>
                    <a:pt x="57306" y="546924"/>
                    <a:pt x="66745" y="540631"/>
                  </a:cubicBezTo>
                  <a:cubicBezTo>
                    <a:pt x="72599" y="536729"/>
                    <a:pt x="70273" y="526901"/>
                    <a:pt x="73419" y="520608"/>
                  </a:cubicBezTo>
                  <a:cubicBezTo>
                    <a:pt x="84543" y="498359"/>
                    <a:pt x="86768" y="500584"/>
                    <a:pt x="106791" y="487235"/>
                  </a:cubicBezTo>
                  <a:cubicBezTo>
                    <a:pt x="111547" y="472967"/>
                    <a:pt x="118044" y="455187"/>
                    <a:pt x="120140" y="440514"/>
                  </a:cubicBezTo>
                  <a:cubicBezTo>
                    <a:pt x="123302" y="418380"/>
                    <a:pt x="124042" y="395956"/>
                    <a:pt x="126815" y="373770"/>
                  </a:cubicBezTo>
                  <a:cubicBezTo>
                    <a:pt x="129392" y="353154"/>
                    <a:pt x="134006" y="327548"/>
                    <a:pt x="140163" y="307025"/>
                  </a:cubicBezTo>
                  <a:cubicBezTo>
                    <a:pt x="144206" y="293548"/>
                    <a:pt x="145707" y="278687"/>
                    <a:pt x="153512" y="266979"/>
                  </a:cubicBezTo>
                  <a:cubicBezTo>
                    <a:pt x="162411" y="253630"/>
                    <a:pt x="166861" y="235831"/>
                    <a:pt x="180210" y="226932"/>
                  </a:cubicBezTo>
                  <a:lnTo>
                    <a:pt x="200234" y="213583"/>
                  </a:lnTo>
                  <a:cubicBezTo>
                    <a:pt x="204683" y="206909"/>
                    <a:pt x="207910" y="199232"/>
                    <a:pt x="213582" y="193560"/>
                  </a:cubicBezTo>
                  <a:cubicBezTo>
                    <a:pt x="219254" y="187888"/>
                    <a:pt x="228324" y="186248"/>
                    <a:pt x="233606" y="180211"/>
                  </a:cubicBezTo>
                  <a:cubicBezTo>
                    <a:pt x="244171" y="168137"/>
                    <a:pt x="246955" y="149063"/>
                    <a:pt x="260304" y="140164"/>
                  </a:cubicBezTo>
                  <a:lnTo>
                    <a:pt x="300350" y="113466"/>
                  </a:lnTo>
                  <a:lnTo>
                    <a:pt x="320374" y="100117"/>
                  </a:lnTo>
                  <a:cubicBezTo>
                    <a:pt x="355971" y="46722"/>
                    <a:pt x="309250" y="111241"/>
                    <a:pt x="353746" y="66745"/>
                  </a:cubicBezTo>
                  <a:cubicBezTo>
                    <a:pt x="398242" y="22249"/>
                    <a:pt x="333723" y="68970"/>
                    <a:pt x="387118" y="33373"/>
                  </a:cubicBezTo>
                  <a:lnTo>
                    <a:pt x="360420" y="0"/>
                  </a:lnTo>
                  <a:close/>
                </a:path>
              </a:pathLst>
            </a:custGeom>
            <a:solidFill>
              <a:srgbClr val="7030A0">
                <a:alpha val="36078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Freeform 45">
              <a:extLst>
                <a:ext uri="{FF2B5EF4-FFF2-40B4-BE49-F238E27FC236}">
                  <a16:creationId xmlns:a16="http://schemas.microsoft.com/office/drawing/2014/main" id="{59C969D3-B85D-F6EC-85D5-953D6A161398}"/>
                </a:ext>
              </a:extLst>
            </p:cNvPr>
            <p:cNvSpPr/>
            <p:nvPr/>
          </p:nvSpPr>
          <p:spPr>
            <a:xfrm>
              <a:off x="4596594" y="2683130"/>
              <a:ext cx="209133" cy="260304"/>
            </a:xfrm>
            <a:custGeom>
              <a:avLst/>
              <a:gdLst>
                <a:gd name="connsiteX0" fmla="*/ 202337 w 209133"/>
                <a:gd name="connsiteY0" fmla="*/ 200234 h 260304"/>
                <a:gd name="connsiteX1" fmla="*/ 202337 w 209133"/>
                <a:gd name="connsiteY1" fmla="*/ 200234 h 260304"/>
                <a:gd name="connsiteX2" fmla="*/ 135593 w 209133"/>
                <a:gd name="connsiteY2" fmla="*/ 160187 h 260304"/>
                <a:gd name="connsiteX3" fmla="*/ 115570 w 209133"/>
                <a:gd name="connsiteY3" fmla="*/ 100117 h 260304"/>
                <a:gd name="connsiteX4" fmla="*/ 108895 w 209133"/>
                <a:gd name="connsiteY4" fmla="*/ 80093 h 260304"/>
                <a:gd name="connsiteX5" fmla="*/ 115570 w 209133"/>
                <a:gd name="connsiteY5" fmla="*/ 26698 h 260304"/>
                <a:gd name="connsiteX6" fmla="*/ 108895 w 209133"/>
                <a:gd name="connsiteY6" fmla="*/ 6674 h 260304"/>
                <a:gd name="connsiteX7" fmla="*/ 82197 w 209133"/>
                <a:gd name="connsiteY7" fmla="*/ 0 h 260304"/>
                <a:gd name="connsiteX8" fmla="*/ 55499 w 209133"/>
                <a:gd name="connsiteY8" fmla="*/ 6674 h 260304"/>
                <a:gd name="connsiteX9" fmla="*/ 48825 w 209133"/>
                <a:gd name="connsiteY9" fmla="*/ 26698 h 260304"/>
                <a:gd name="connsiteX10" fmla="*/ 15453 w 209133"/>
                <a:gd name="connsiteY10" fmla="*/ 60070 h 260304"/>
                <a:gd name="connsiteX11" fmla="*/ 8778 w 209133"/>
                <a:gd name="connsiteY11" fmla="*/ 113466 h 260304"/>
                <a:gd name="connsiteX12" fmla="*/ 28802 w 209133"/>
                <a:gd name="connsiteY12" fmla="*/ 126815 h 260304"/>
                <a:gd name="connsiteX13" fmla="*/ 42151 w 209133"/>
                <a:gd name="connsiteY13" fmla="*/ 146838 h 260304"/>
                <a:gd name="connsiteX14" fmla="*/ 62174 w 209133"/>
                <a:gd name="connsiteY14" fmla="*/ 160187 h 260304"/>
                <a:gd name="connsiteX15" fmla="*/ 88872 w 209133"/>
                <a:gd name="connsiteY15" fmla="*/ 200234 h 260304"/>
                <a:gd name="connsiteX16" fmla="*/ 95546 w 209133"/>
                <a:gd name="connsiteY16" fmla="*/ 220257 h 260304"/>
                <a:gd name="connsiteX17" fmla="*/ 108895 w 209133"/>
                <a:gd name="connsiteY17" fmla="*/ 240280 h 260304"/>
                <a:gd name="connsiteX18" fmla="*/ 148942 w 209133"/>
                <a:gd name="connsiteY18" fmla="*/ 260304 h 260304"/>
                <a:gd name="connsiteX19" fmla="*/ 209012 w 209133"/>
                <a:gd name="connsiteY19" fmla="*/ 233606 h 260304"/>
                <a:gd name="connsiteX20" fmla="*/ 202337 w 209133"/>
                <a:gd name="connsiteY20" fmla="*/ 200234 h 2603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</a:cxnLst>
              <a:rect l="l" t="t" r="r" b="b"/>
              <a:pathLst>
                <a:path w="209133" h="260304">
                  <a:moveTo>
                    <a:pt x="202337" y="200234"/>
                  </a:moveTo>
                  <a:lnTo>
                    <a:pt x="202337" y="200234"/>
                  </a:lnTo>
                  <a:cubicBezTo>
                    <a:pt x="164080" y="185887"/>
                    <a:pt x="149929" y="192442"/>
                    <a:pt x="135593" y="160187"/>
                  </a:cubicBezTo>
                  <a:cubicBezTo>
                    <a:pt x="135589" y="160177"/>
                    <a:pt x="118909" y="110134"/>
                    <a:pt x="115570" y="100117"/>
                  </a:cubicBezTo>
                  <a:lnTo>
                    <a:pt x="108895" y="80093"/>
                  </a:lnTo>
                  <a:cubicBezTo>
                    <a:pt x="111120" y="62295"/>
                    <a:pt x="115570" y="44635"/>
                    <a:pt x="115570" y="26698"/>
                  </a:cubicBezTo>
                  <a:cubicBezTo>
                    <a:pt x="115570" y="19662"/>
                    <a:pt x="114389" y="11069"/>
                    <a:pt x="108895" y="6674"/>
                  </a:cubicBezTo>
                  <a:cubicBezTo>
                    <a:pt x="101732" y="944"/>
                    <a:pt x="91096" y="2225"/>
                    <a:pt x="82197" y="0"/>
                  </a:cubicBezTo>
                  <a:cubicBezTo>
                    <a:pt x="73298" y="2225"/>
                    <a:pt x="62662" y="944"/>
                    <a:pt x="55499" y="6674"/>
                  </a:cubicBezTo>
                  <a:cubicBezTo>
                    <a:pt x="50005" y="11069"/>
                    <a:pt x="51971" y="20405"/>
                    <a:pt x="48825" y="26698"/>
                  </a:cubicBezTo>
                  <a:cubicBezTo>
                    <a:pt x="37702" y="48945"/>
                    <a:pt x="35475" y="46722"/>
                    <a:pt x="15453" y="60070"/>
                  </a:cubicBezTo>
                  <a:cubicBezTo>
                    <a:pt x="1643" y="80784"/>
                    <a:pt x="-7717" y="84599"/>
                    <a:pt x="8778" y="113466"/>
                  </a:cubicBezTo>
                  <a:cubicBezTo>
                    <a:pt x="12758" y="120431"/>
                    <a:pt x="22127" y="122365"/>
                    <a:pt x="28802" y="126815"/>
                  </a:cubicBezTo>
                  <a:cubicBezTo>
                    <a:pt x="33252" y="133489"/>
                    <a:pt x="36479" y="141166"/>
                    <a:pt x="42151" y="146838"/>
                  </a:cubicBezTo>
                  <a:cubicBezTo>
                    <a:pt x="47823" y="152510"/>
                    <a:pt x="56892" y="154150"/>
                    <a:pt x="62174" y="160187"/>
                  </a:cubicBezTo>
                  <a:cubicBezTo>
                    <a:pt x="72739" y="172261"/>
                    <a:pt x="88872" y="200234"/>
                    <a:pt x="88872" y="200234"/>
                  </a:cubicBezTo>
                  <a:cubicBezTo>
                    <a:pt x="91097" y="206908"/>
                    <a:pt x="92400" y="213964"/>
                    <a:pt x="95546" y="220257"/>
                  </a:cubicBezTo>
                  <a:cubicBezTo>
                    <a:pt x="99133" y="227432"/>
                    <a:pt x="103223" y="234608"/>
                    <a:pt x="108895" y="240280"/>
                  </a:cubicBezTo>
                  <a:cubicBezTo>
                    <a:pt x="121834" y="253219"/>
                    <a:pt x="132656" y="254875"/>
                    <a:pt x="148942" y="260304"/>
                  </a:cubicBezTo>
                  <a:cubicBezTo>
                    <a:pt x="193243" y="254766"/>
                    <a:pt x="202970" y="269857"/>
                    <a:pt x="209012" y="233606"/>
                  </a:cubicBezTo>
                  <a:cubicBezTo>
                    <a:pt x="210109" y="227022"/>
                    <a:pt x="203449" y="205796"/>
                    <a:pt x="202337" y="200234"/>
                  </a:cubicBezTo>
                  <a:close/>
                </a:path>
              </a:pathLst>
            </a:custGeom>
            <a:solidFill>
              <a:srgbClr val="7030A0">
                <a:alpha val="36078"/>
              </a:srgb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705088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4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Eden, Emily</dc:creator>
  <cp:keywords/>
  <dc:description/>
  <cp:lastModifiedBy>Eden, Emily</cp:lastModifiedBy>
  <cp:revision>3</cp:revision>
  <dcterms:created xsi:type="dcterms:W3CDTF">2025-01-08T17:05:16Z</dcterms:created>
  <dcterms:modified xsi:type="dcterms:W3CDTF">2025-01-08T18:31:15Z</dcterms:modified>
  <cp:category/>
</cp:coreProperties>
</file>